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0"/>
  </p:notesMasterIdLst>
  <p:sldIdLst>
    <p:sldId id="298" r:id="rId2"/>
    <p:sldId id="299" r:id="rId3"/>
    <p:sldId id="300" r:id="rId4"/>
    <p:sldId id="301" r:id="rId5"/>
    <p:sldId id="302" r:id="rId6"/>
    <p:sldId id="315" r:id="rId7"/>
    <p:sldId id="303" r:id="rId8"/>
    <p:sldId id="304" r:id="rId9"/>
    <p:sldId id="305" r:id="rId10"/>
    <p:sldId id="306" r:id="rId11"/>
    <p:sldId id="307" r:id="rId12"/>
    <p:sldId id="308" r:id="rId13"/>
    <p:sldId id="309" r:id="rId14"/>
    <p:sldId id="310" r:id="rId15"/>
    <p:sldId id="311" r:id="rId16"/>
    <p:sldId id="312" r:id="rId17"/>
    <p:sldId id="313" r:id="rId18"/>
    <p:sldId id="314" r:id="rId19"/>
  </p:sldIdLst>
  <p:sldSz cx="6858000" cy="9906000" type="A4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ga" initials="O" lastIdx="1" clrIdx="0">
    <p:extLst>
      <p:ext uri="{19B8F6BF-5375-455C-9EA6-DF929625EA0E}">
        <p15:presenceInfo xmlns:p15="http://schemas.microsoft.com/office/powerpoint/2012/main" userId="Olg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ADD8E6"/>
    <a:srgbClr val="9ACD32"/>
    <a:srgbClr val="006400"/>
    <a:srgbClr val="FFA500"/>
    <a:srgbClr val="FFD700"/>
    <a:srgbClr val="1F78B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7"/>
    <p:restoredTop sz="96366" autoAdjust="0"/>
  </p:normalViewPr>
  <p:slideViewPr>
    <p:cSldViewPr snapToGrid="0">
      <p:cViewPr varScale="1">
        <p:scale>
          <a:sx n="75" d="100"/>
          <a:sy n="75" d="100"/>
        </p:scale>
        <p:origin x="2538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6ACF1A-4B5C-4CE6-9F5B-297FBA07B3BD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0125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777194"/>
            <a:ext cx="548640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4967DA-433D-4245-B366-A54B8E44047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3177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478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42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755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998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646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726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479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290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120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112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722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3DD2DC-BC64-4344-8D65-5CA75B42B68A}" type="datetimeFigureOut">
              <a:rPr lang="en-US" smtClean="0"/>
              <a:t>8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67D23-38ED-4F7A-AE09-9CCD2D411DE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45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5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F7282DF-3506-8294-8D20-31C336802CC3}"/>
              </a:ext>
            </a:extLst>
          </p:cNvPr>
          <p:cNvSpPr txBox="1"/>
          <p:nvPr/>
        </p:nvSpPr>
        <p:spPr>
          <a:xfrm>
            <a:off x="-9759" y="496362"/>
            <a:ext cx="6987810" cy="8588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CA" sz="1400" b="1" dirty="0">
                <a:effectLst/>
              </a:rPr>
              <a:t>Supplemental dataset 5 : Isolation and compound characterization of diterpenoids</a:t>
            </a:r>
          </a:p>
          <a:p>
            <a:pPr algn="just"/>
            <a:endParaRPr lang="en-JP" sz="1400" b="1" dirty="0">
              <a:effectLst/>
            </a:endParaRPr>
          </a:p>
          <a:p>
            <a:pPr algn="just"/>
            <a:r>
              <a:rPr lang="en-CA" sz="1050" dirty="0">
                <a:effectLst/>
                <a:ea typeface="SimSun" panose="02010600030101010101" pitchFamily="2" charset="-122"/>
              </a:rPr>
              <a:t>Article title: </a:t>
            </a:r>
            <a:r>
              <a:rPr lang="en-US" sz="1050" b="1" dirty="0">
                <a:effectLst/>
                <a:ea typeface="Yu Mincho" panose="02020400000000000000" pitchFamily="18" charset="-128"/>
                <a:cs typeface="Arial" panose="020B0604020202020204" pitchFamily="34" charset="0"/>
              </a:rPr>
              <a:t>Consequences of interspecific plant hybridization on metabolic diversity in naturally occurring hybrid swarms</a:t>
            </a:r>
            <a:r>
              <a:rPr lang="en-JP" sz="1050" b="1" dirty="0">
                <a:effectLst/>
                <a:cs typeface="Arial" panose="020B0604020202020204" pitchFamily="34" charset="0"/>
              </a:rPr>
              <a:t> </a:t>
            </a:r>
          </a:p>
          <a:p>
            <a:pPr algn="just"/>
            <a:r>
              <a:rPr lang="en-CA" sz="1050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 </a:t>
            </a:r>
          </a:p>
          <a:p>
            <a:pPr algn="just">
              <a:spcAft>
                <a:spcPts val="200"/>
              </a:spcAft>
            </a:pPr>
            <a:r>
              <a:rPr lang="en-CA" sz="1050" dirty="0">
                <a:effectLst/>
                <a:ea typeface="SimSun" panose="02010600030101010101" pitchFamily="2" charset="-122"/>
              </a:rPr>
              <a:t>Authors: </a:t>
            </a:r>
            <a:r>
              <a:rPr lang="en-US" sz="1050" dirty="0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Olga </a:t>
            </a:r>
            <a:r>
              <a:rPr lang="en-US" sz="1050" dirty="0" err="1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Zafra</a:t>
            </a:r>
            <a:r>
              <a:rPr lang="en-US" sz="1050" dirty="0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-Delgado, Fabian Schneider, Yoko Nakamura, Michael </a:t>
            </a:r>
            <a:r>
              <a:rPr lang="en-US" sz="1050" dirty="0" err="1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Reichelt</a:t>
            </a:r>
            <a:r>
              <a:rPr lang="en-US" sz="1050" dirty="0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, Jonathan </a:t>
            </a:r>
            <a:r>
              <a:rPr lang="en-US" sz="1050" dirty="0" err="1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Gershenzon</a:t>
            </a:r>
            <a:r>
              <a:rPr lang="en-US" sz="1050" dirty="0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, </a:t>
            </a:r>
          </a:p>
          <a:p>
            <a:pPr algn="just">
              <a:spcAft>
                <a:spcPts val="200"/>
              </a:spcAft>
            </a:pPr>
            <a:r>
              <a:rPr lang="en-US" sz="1050" dirty="0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                 Frank H. </a:t>
            </a:r>
            <a:r>
              <a:rPr lang="en-US" sz="1050" dirty="0" err="1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Hellwig</a:t>
            </a:r>
            <a:r>
              <a:rPr lang="en-US" sz="1050" dirty="0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, Tobias G. </a:t>
            </a:r>
            <a:r>
              <a:rPr lang="en-US" sz="1050" dirty="0" err="1">
                <a:effectLst/>
                <a:ea typeface="Yu Mincho" panose="02020400000000000000" pitchFamily="18" charset="-128"/>
                <a:cs typeface="Calibri" panose="020F0502020204030204" pitchFamily="34" charset="0"/>
              </a:rPr>
              <a:t>Köllner</a:t>
            </a:r>
            <a:endParaRPr lang="en-JP" sz="1050" dirty="0">
              <a:effectLst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endParaRPr lang="en-JP" sz="1050" dirty="0">
              <a:effectLst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50000"/>
              </a:lnSpc>
            </a:pPr>
            <a:r>
              <a:rPr lang="en-CA" sz="1050" b="1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S1  Methods for compound characterization and isolation</a:t>
            </a:r>
            <a:endParaRPr lang="en-JP" sz="1050" dirty="0">
              <a:effectLst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50000"/>
              </a:lnSpc>
            </a:pPr>
            <a:r>
              <a:rPr lang="en-CA" sz="1050" b="1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S2  HR-ESI-MS (high-resolution electrospray ionization mass spectrometry) data of the diterpenoids</a:t>
            </a:r>
          </a:p>
          <a:p>
            <a:pPr>
              <a:lnSpc>
                <a:spcPct val="250000"/>
              </a:lnSpc>
            </a:pPr>
            <a:r>
              <a:rPr lang="en-CA" sz="1050" b="1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S3  NMR assignment of the diterpenoids</a:t>
            </a:r>
          </a:p>
          <a:p>
            <a:pPr>
              <a:lnSpc>
                <a:spcPct val="250000"/>
              </a:lnSpc>
            </a:pPr>
            <a:r>
              <a:rPr lang="en-CA" sz="1050" dirty="0">
                <a:ea typeface="SimSun" panose="02010600030101010101" pitchFamily="2" charset="-122"/>
                <a:cs typeface="Arial" panose="020B0604020202020204" pitchFamily="34" charset="0"/>
              </a:rPr>
              <a:t>S3.1</a:t>
            </a:r>
            <a:r>
              <a:rPr lang="de-DE" sz="1050" dirty="0">
                <a:ea typeface="MS Mincho"/>
              </a:rPr>
              <a:t>  NMR </a:t>
            </a:r>
            <a:r>
              <a:rPr lang="de-DE" sz="1050" dirty="0" err="1">
                <a:ea typeface="MS Mincho"/>
              </a:rPr>
              <a:t>dat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 err="1"/>
              <a:t>bacchasmacranone</a:t>
            </a:r>
            <a:endParaRPr lang="en-US" sz="1050" dirty="0"/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3.2  NMR </a:t>
            </a:r>
            <a:r>
              <a:rPr lang="de-DE" sz="1050" dirty="0" err="1">
                <a:ea typeface="MS Mincho"/>
              </a:rPr>
              <a:t>dat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8-</a:t>
            </a:r>
            <a:r>
              <a:rPr lang="de-DE" sz="1050" i="1" dirty="0">
                <a:ea typeface="MS Mincho"/>
              </a:rPr>
              <a:t>epi</a:t>
            </a:r>
            <a:r>
              <a:rPr lang="de-DE" sz="1050" dirty="0">
                <a:ea typeface="MS Mincho"/>
              </a:rPr>
              <a:t>-</a:t>
            </a:r>
            <a:r>
              <a:rPr lang="en-US" sz="1050" dirty="0" err="1"/>
              <a:t>bacchasmacranone</a:t>
            </a:r>
            <a:endParaRPr lang="en-US" sz="1050" dirty="0"/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3-3 </a:t>
            </a:r>
            <a:r>
              <a:rPr lang="de-DE" sz="1050" b="1" dirty="0">
                <a:ea typeface="MS Mincho"/>
              </a:rPr>
              <a:t>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dat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/>
              <a:t>2</a:t>
            </a:r>
            <a:r>
              <a:rPr lang="en-US" sz="1050" dirty="0">
                <a:latin typeface="Symbol" panose="05050102010706020507" pitchFamily="18" charset="2"/>
              </a:rPr>
              <a:t>b</a:t>
            </a:r>
            <a:r>
              <a:rPr lang="en-US" sz="1050" dirty="0"/>
              <a:t>-hydroxy-hautriwaic lactone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3-4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dat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/>
              <a:t>1-deoxybacrispine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3-5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dat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en-US" sz="1050" dirty="0"/>
              <a:t> 18-dihydro-conyscabrafuran 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3-6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dat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 err="1"/>
              <a:t>hautriwaic</a:t>
            </a:r>
            <a:r>
              <a:rPr lang="en-US" sz="1050" dirty="0"/>
              <a:t> acid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3-7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dat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 err="1"/>
              <a:t>hardwickiic</a:t>
            </a:r>
            <a:r>
              <a:rPr lang="en-US" sz="1050" dirty="0"/>
              <a:t> acid</a:t>
            </a:r>
          </a:p>
          <a:p>
            <a:pPr>
              <a:lnSpc>
                <a:spcPct val="250000"/>
              </a:lnSpc>
            </a:pPr>
            <a:r>
              <a:rPr lang="en-JP" sz="1050" b="1" dirty="0">
                <a:ea typeface="SimSun" panose="02010600030101010101" pitchFamily="2" charset="-122"/>
                <a:cs typeface="Arial" panose="020B0604020202020204" pitchFamily="34" charset="0"/>
              </a:rPr>
              <a:t>S4  NMR spectra of the diterpenoids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4-1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spectr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 err="1"/>
              <a:t>bacchasmacranone</a:t>
            </a:r>
            <a:endParaRPr lang="en-US" sz="1050" dirty="0"/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4-2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spectr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8-</a:t>
            </a:r>
            <a:r>
              <a:rPr lang="de-DE" sz="1050" i="1" dirty="0">
                <a:ea typeface="MS Mincho"/>
              </a:rPr>
              <a:t>epi</a:t>
            </a:r>
            <a:r>
              <a:rPr lang="de-DE" sz="1050" dirty="0">
                <a:ea typeface="MS Mincho"/>
              </a:rPr>
              <a:t>-</a:t>
            </a:r>
            <a:r>
              <a:rPr lang="en-US" sz="1050" dirty="0" err="1"/>
              <a:t>bacchasmacranone</a:t>
            </a:r>
            <a:endParaRPr lang="en-US" sz="1050" dirty="0"/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4-3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spectr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/>
              <a:t>2</a:t>
            </a:r>
            <a:r>
              <a:rPr lang="en-US" sz="1050" dirty="0">
                <a:latin typeface="Symbol" panose="05050102010706020507" pitchFamily="18" charset="2"/>
              </a:rPr>
              <a:t>b</a:t>
            </a:r>
            <a:r>
              <a:rPr lang="en-US" sz="1050" dirty="0"/>
              <a:t>-hydroxy-hautriwaic lactone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4-4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spectr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/>
              <a:t>1-deoxybacrispine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4-5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spectr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/>
              <a:t>18-dihydro-conyscabrafuran 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4-6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spectr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 err="1"/>
              <a:t>hautriwaic</a:t>
            </a:r>
            <a:r>
              <a:rPr lang="en-US" sz="1050" dirty="0"/>
              <a:t> acid</a:t>
            </a:r>
          </a:p>
          <a:p>
            <a:pPr>
              <a:lnSpc>
                <a:spcPct val="250000"/>
              </a:lnSpc>
            </a:pPr>
            <a:r>
              <a:rPr lang="de-DE" sz="1050" dirty="0">
                <a:ea typeface="MS Mincho"/>
              </a:rPr>
              <a:t>S4-7</a:t>
            </a:r>
            <a:r>
              <a:rPr lang="de-DE" sz="1050" b="1" dirty="0">
                <a:ea typeface="MS Mincho"/>
              </a:rPr>
              <a:t>  </a:t>
            </a:r>
            <a:r>
              <a:rPr lang="de-DE" sz="1050" dirty="0">
                <a:ea typeface="MS Mincho"/>
              </a:rPr>
              <a:t>NMR </a:t>
            </a:r>
            <a:r>
              <a:rPr lang="de-DE" sz="1050" dirty="0" err="1">
                <a:ea typeface="MS Mincho"/>
              </a:rPr>
              <a:t>spectra</a:t>
            </a:r>
            <a:r>
              <a:rPr lang="de-DE" sz="1050" dirty="0">
                <a:ea typeface="MS Mincho"/>
              </a:rPr>
              <a:t> </a:t>
            </a:r>
            <a:r>
              <a:rPr lang="de-DE" sz="1050" dirty="0" err="1">
                <a:ea typeface="MS Mincho"/>
              </a:rPr>
              <a:t>for</a:t>
            </a:r>
            <a:r>
              <a:rPr lang="de-DE" sz="1050" dirty="0">
                <a:ea typeface="MS Mincho"/>
              </a:rPr>
              <a:t> </a:t>
            </a:r>
            <a:r>
              <a:rPr lang="en-US" sz="1050" dirty="0" err="1"/>
              <a:t>hardwickiic</a:t>
            </a:r>
            <a:r>
              <a:rPr lang="en-US" sz="1050" dirty="0"/>
              <a:t> acid</a:t>
            </a:r>
          </a:p>
        </p:txBody>
      </p:sp>
    </p:spTree>
    <p:extLst>
      <p:ext uri="{BB962C8B-B14F-4D97-AF65-F5344CB8AC3E}">
        <p14:creationId xmlns:p14="http://schemas.microsoft.com/office/powerpoint/2010/main" val="28779555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3151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2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8-</a:t>
            </a:r>
            <a:r>
              <a:rPr lang="de-DE" sz="1200" i="1" dirty="0">
                <a:ea typeface="MS Mincho"/>
              </a:rPr>
              <a:t>epi</a:t>
            </a:r>
            <a:r>
              <a:rPr lang="de-DE" sz="1200" dirty="0">
                <a:ea typeface="MS Mincho"/>
              </a:rPr>
              <a:t>-</a:t>
            </a:r>
            <a:r>
              <a:rPr lang="en-US" sz="1200" dirty="0" err="1"/>
              <a:t>bacchasmacranone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95173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COSY, </a:t>
            </a:r>
            <a:r>
              <a:rPr lang="en-US" sz="1200" baseline="30000" dirty="0"/>
              <a:t> </a:t>
            </a:r>
            <a:r>
              <a:rPr lang="en-US" sz="1200" dirty="0"/>
              <a:t>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549744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ROESY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840099B-E956-4A12-A8B1-462AAD729F1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1332" y="221807"/>
            <a:ext cx="596438" cy="9767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230" y="833418"/>
            <a:ext cx="5683568" cy="40490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289" y="5549744"/>
            <a:ext cx="5614988" cy="40490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195724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3486147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3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2</a:t>
            </a:r>
            <a:r>
              <a:rPr lang="en-US" sz="1200" dirty="0">
                <a:latin typeface="Symbol" panose="05050102010706020507" pitchFamily="18" charset="2"/>
              </a:rPr>
              <a:t>b</a:t>
            </a:r>
            <a:r>
              <a:rPr lang="en-US" sz="1200" dirty="0"/>
              <a:t>-hydroxy-hautriwaic lactone</a:t>
            </a:r>
          </a:p>
          <a:p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95173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/>
              <a:t>1</a:t>
            </a:r>
            <a:r>
              <a:rPr lang="en-US" sz="1200" dirty="0"/>
              <a:t>H NMR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272744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DEPTQ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B657BFE-432E-4A62-8F5E-8ACF9D2C479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5650" y="1018393"/>
            <a:ext cx="731520" cy="9767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6C1291A-E7C0-4BFC-9C2B-7432F41389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306" y="1069797"/>
            <a:ext cx="5912168" cy="380333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498CA4B-A902-4DF6-9088-CE39345956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1171" y="5707743"/>
            <a:ext cx="5786438" cy="3911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696119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3478325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3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2</a:t>
            </a:r>
            <a:r>
              <a:rPr lang="en-US" sz="1200" dirty="0">
                <a:latin typeface="Symbol" panose="05050102010706020507" pitchFamily="18" charset="2"/>
              </a:rPr>
              <a:t>b</a:t>
            </a:r>
            <a:r>
              <a:rPr lang="en-US" sz="1200" dirty="0"/>
              <a:t>-hydroxy hautriwaic lactone</a:t>
            </a:r>
          </a:p>
          <a:p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7299" y="479696"/>
            <a:ext cx="4537396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ELTOCSY in CDCl</a:t>
            </a:r>
            <a:r>
              <a:rPr lang="en-US" sz="1200" baseline="-25000" dirty="0"/>
              <a:t>3</a:t>
            </a:r>
            <a:r>
              <a:rPr lang="en-US" sz="1200" dirty="0"/>
              <a:t>,</a:t>
            </a:r>
            <a:r>
              <a:rPr lang="en-US" sz="1200" dirty="0">
                <a:solidFill>
                  <a:srgbClr val="FF0000"/>
                </a:solidFill>
              </a:rPr>
              <a:t> </a:t>
            </a:r>
            <a:r>
              <a:rPr lang="en-US" sz="1200" dirty="0"/>
              <a:t>transmitter frequency 1.96 ppm</a:t>
            </a:r>
          </a:p>
          <a:p>
            <a:r>
              <a:rPr lang="en-US" sz="1400" baseline="-25000" dirty="0"/>
              <a:t> </a:t>
            </a:r>
            <a:endParaRPr lang="en-US" sz="14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B657BFE-432E-4A62-8F5E-8ACF9D2C479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5650" y="1340078"/>
            <a:ext cx="731520" cy="9767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125E07C1-0561-4479-968D-43A9DD565167}"/>
              </a:ext>
            </a:extLst>
          </p:cNvPr>
          <p:cNvSpPr txBox="1"/>
          <p:nvPr/>
        </p:nvSpPr>
        <p:spPr>
          <a:xfrm>
            <a:off x="147300" y="5830550"/>
            <a:ext cx="453739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ELTOCSY in CDCl</a:t>
            </a:r>
            <a:r>
              <a:rPr lang="en-US" sz="1200" baseline="-25000" dirty="0"/>
              <a:t>3</a:t>
            </a:r>
            <a:r>
              <a:rPr lang="en-US" sz="1200" dirty="0"/>
              <a:t>,</a:t>
            </a:r>
            <a:r>
              <a:rPr lang="en-US" sz="1200" dirty="0">
                <a:solidFill>
                  <a:srgbClr val="FF0000"/>
                </a:solidFill>
              </a:rPr>
              <a:t> </a:t>
            </a:r>
            <a:r>
              <a:rPr lang="en-US" sz="1200" dirty="0"/>
              <a:t>transmitter frequency 1.86 ppm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46BE768-0247-4648-9294-66F3E7472D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0058" y="787493"/>
            <a:ext cx="5917883" cy="373189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C1982CB-81D1-4AC9-8120-69217B2457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0071" y="5830550"/>
            <a:ext cx="5697855" cy="3731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613422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2725683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4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1-deoxybacrispine</a:t>
            </a:r>
          </a:p>
          <a:p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83068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/>
              <a:t>1</a:t>
            </a:r>
            <a:r>
              <a:rPr lang="en-US" sz="1200" dirty="0"/>
              <a:t>H NMR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365954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DEPTQ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111A069-C9FA-40AA-A56A-CC900AEDC2F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494" y="934172"/>
            <a:ext cx="648393" cy="9767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A577ECA-7734-4464-8CD5-8B3A30095E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6787" y="1018393"/>
            <a:ext cx="5803583" cy="380333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5D3B77B-A548-47B8-B982-8835EC0ABF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202" y="5816342"/>
            <a:ext cx="5903595" cy="3911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957521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3367910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5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18-dihydro-conyscabrafuran </a:t>
            </a:r>
          </a:p>
          <a:p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95173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/>
              <a:t>1</a:t>
            </a:r>
            <a:r>
              <a:rPr lang="en-US" sz="1200" dirty="0"/>
              <a:t>H NMR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19194" y="5365954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DEPTQ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A21ED67-F7ED-4C40-BC8F-78A52F1413B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4888" y="1018393"/>
            <a:ext cx="592282" cy="8624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8805A99-04F5-4DDF-9C73-4CECFCFE55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485" y="1018393"/>
            <a:ext cx="5955030" cy="380333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DFB14A7-E0AA-461B-98F2-C7CBE88885C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485" y="5816342"/>
            <a:ext cx="5923598" cy="3911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05922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95" y="1018393"/>
            <a:ext cx="5975033" cy="38919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3367910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5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18-dihydro-conyscabrafuran </a:t>
            </a:r>
          </a:p>
          <a:p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95173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phase sensitive HSQC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520464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HMBC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A21ED67-F7ED-4C40-BC8F-78A52F1413B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2149" y="269737"/>
            <a:ext cx="592282" cy="8624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2173" y="5549744"/>
            <a:ext cx="5629275" cy="38919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9126156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3332644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5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18-dihydro-conyscabrafuran </a:t>
            </a:r>
          </a:p>
          <a:p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95173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COSY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561117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ROESY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A21ED67-F7ED-4C40-BC8F-78A52F1413B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5484" y="232143"/>
            <a:ext cx="592282" cy="8624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523" y="1061240"/>
            <a:ext cx="5769293" cy="40490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676" y="5549744"/>
            <a:ext cx="5692140" cy="40490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5701645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2534605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6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hautriwaic acid</a:t>
            </a:r>
          </a:p>
          <a:p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59567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/>
              <a:t>1</a:t>
            </a:r>
            <a:r>
              <a:rPr lang="en-US" sz="1200" dirty="0"/>
              <a:t>H NMR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227025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DEPTQ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BC75D99-28E1-4586-9410-E33C91ED3D7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277" y="1120383"/>
            <a:ext cx="577735" cy="1001684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C226946-C9A9-4AEF-A21C-6D0F35E240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4341" y="802950"/>
            <a:ext cx="5969318" cy="380333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32873A8-0317-4438-A630-C64DE47E8B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761" y="5701940"/>
            <a:ext cx="5855018" cy="3911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614414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4" y="177740"/>
            <a:ext cx="3974135" cy="4924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ea typeface="MS Mincho"/>
              </a:rPr>
              <a:t>S4-7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hardwickiic acid</a:t>
            </a:r>
          </a:p>
          <a:p>
            <a:r>
              <a:rPr lang="de-DE" sz="1400" dirty="0">
                <a:ea typeface="MS Mincho"/>
              </a:rPr>
              <a:t>  </a:t>
            </a:r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33181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/>
              <a:t>1</a:t>
            </a:r>
            <a:r>
              <a:rPr lang="en-US" sz="1200" dirty="0"/>
              <a:t>H NMR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4" y="5241968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DEPTQ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7F295AA-E7B7-4351-BB2B-F8ABFA1CAAC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8727" y="1120383"/>
            <a:ext cx="577735" cy="1001684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2919DB8-5DD5-4C82-AD81-CE75E40D82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386" y="5688630"/>
            <a:ext cx="5937885" cy="391191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224047C-1CFC-49BD-8186-3074FB5DDFC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9171" y="860700"/>
            <a:ext cx="5986463" cy="3803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99928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6E74994-E1DF-CC40-360B-27FCC038B609}"/>
              </a:ext>
            </a:extLst>
          </p:cNvPr>
          <p:cNvSpPr txBox="1"/>
          <p:nvPr/>
        </p:nvSpPr>
        <p:spPr>
          <a:xfrm>
            <a:off x="303609" y="340965"/>
            <a:ext cx="6250781" cy="8831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50000"/>
              </a:lnSpc>
            </a:pPr>
            <a:r>
              <a:rPr lang="en-CA" sz="1050" b="1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S1  Methods for compound characterization and isolation</a:t>
            </a:r>
          </a:p>
          <a:p>
            <a:pPr>
              <a:lnSpc>
                <a:spcPct val="250000"/>
              </a:lnSpc>
            </a:pPr>
            <a:endParaRPr lang="en-JP" sz="1200" dirty="0">
              <a:effectLst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41A9EEC-7B85-28BE-3730-DFB186F8FAB4}"/>
              </a:ext>
            </a:extLst>
          </p:cNvPr>
          <p:cNvSpPr txBox="1"/>
          <p:nvPr/>
        </p:nvSpPr>
        <p:spPr>
          <a:xfrm>
            <a:off x="303609" y="782528"/>
            <a:ext cx="6250781" cy="5539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JP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NMR measurements were carried out on a 700 MHz Bruker Avance III HD spectrometer (Bruker Biospin GmbH, Rheinstetten, Germany), equipped with a TCI cryoprobe using standard pulse sequences as implemented in Bruker Topspin ver. 3.6.1. Chemical shifts were referenced to the residual solvent signals of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DCl</a:t>
            </a:r>
            <a:r>
              <a:rPr lang="en-JP" sz="1050" kern="1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3</a:t>
            </a:r>
            <a:r>
              <a:rPr lang="en-JP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(</a:t>
            </a:r>
            <a:r>
              <a:rPr lang="en-JP" sz="1050" kern="100" dirty="0">
                <a:solidFill>
                  <a:srgbClr val="000000"/>
                </a:solidFill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d</a:t>
            </a:r>
            <a:r>
              <a:rPr lang="en-JP" sz="1050" kern="1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JP" sz="1050" kern="100" baseline="30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7.26</a:t>
            </a:r>
            <a:r>
              <a:rPr lang="en-JP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/</a:t>
            </a:r>
            <a:r>
              <a:rPr lang="en-JP" sz="1050" kern="100" dirty="0">
                <a:solidFill>
                  <a:srgbClr val="000000"/>
                </a:solidFill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d</a:t>
            </a:r>
            <a:r>
              <a:rPr lang="en-JP" sz="1050" kern="1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</a:t>
            </a:r>
            <a:r>
              <a:rPr lang="en-JP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77.16</a:t>
            </a:r>
            <a:r>
              <a:rPr lang="en-JP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).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LC-MS analyses were performed on an Agilent Infinity 1260 system (Agilent Technologies GmbH, Santa Clara, CA, USA) using an Agilent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Poroshell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120 EC-C18 column, 2.7 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m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, 4.6 x 50 mm (Agilent Technologies) connected to a Bruker Compact OTOF mass spectrometer (Bruker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Daltonics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GmbH, Bremen, Germany). For liquid chromatography, a solvent system of H</a:t>
            </a:r>
            <a:r>
              <a:rPr lang="en-US" sz="1050" kern="1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 (solvent A) and acetonitrile (solvent B) both containing 0.1 % (v/v) formic acid (FA), was used with a flow rate 0.4 mL/min. The column temperature was maintained at 40 °C. The following gradient was used: 0-1 min, 50% B; 1-9 min, 50-90% B; 9-11 min, 90% B; 11-12 min, 90-50% B, 12-15 min, 50% B. HR-ESI-MS (high-resolution electrospray ionization mass spectrometry) data were acquired in positive ionization mode. Preparative HPLC separations were carried out using an Agilent 1100 HPLC system (Agilent) connected to an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Advantec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CHF122SB fraction collector (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Advantec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Toyo Kaisha Ltd., Tokyo, Japan) using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acherey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-Nagel (MN) columns (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acherey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-Nagel GmbH,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Düren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, Germany). Silica gel flash column chromatography was accomplished using a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Biotage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Isolera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One chromatograph (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Biotage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Sweden AB, Uppsala, Sweden). Preparative silica gel thin-layer chromatography (p-TLC) was conducted using TLC silica gel 60 F</a:t>
            </a:r>
            <a:r>
              <a:rPr lang="en-US" sz="1050" kern="1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54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plates and TLC silica gel 60 RP-18 F</a:t>
            </a:r>
            <a:r>
              <a:rPr lang="en-US" sz="1050" kern="1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54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plates (Merck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KGaA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, Darmstadt, Germany).</a:t>
            </a:r>
          </a:p>
          <a:p>
            <a:pPr algn="just"/>
            <a:endParaRPr lang="en-US" sz="1050" kern="100" dirty="0">
              <a:solidFill>
                <a:srgbClr val="000000"/>
              </a:solidFill>
              <a:effectLst/>
              <a:latin typeface="Calibri" panose="020F050202020403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pPr algn="just"/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For diterpenoid isolation, the one third of ethyl acetate extract of the leaves of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B. </a:t>
            </a:r>
            <a:r>
              <a:rPr lang="en-US" sz="1050" i="1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acraei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(560 g FW)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was separated twice by silica gel flash column chromatography (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tOA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/Hexane, first; 0-100 %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tOA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, second; 0-60%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tOA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) to give fractions A-1 to A-7. The fraction A-5 was separated by amino-functionalized silica gel flash column chromatography to give fractions B-1 to B-4. The fractions B-1 and B-2 were subjected to reverse phase HPLC (MN </a:t>
            </a:r>
            <a:r>
              <a:rPr lang="en-US" sz="1050" kern="100" dirty="0"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p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-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olumn, 5 </a:t>
            </a:r>
            <a:r>
              <a:rPr lang="en-US" sz="1050" kern="100" dirty="0"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m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, 250 x 4.6 mm,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eCN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/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 + 0.1%FA for each, 50-90%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eCN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) to afford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bacchasmacranone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(13 mg) and 8-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pi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-bacchasmacranone (2.4 mg). The fraction B-4 was further separated by normal phase p-TLC (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tOA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/Hexane = 1: 1) to give 2</a:t>
            </a:r>
            <a:r>
              <a:rPr lang="en-US" sz="1050" kern="100" dirty="0"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b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-hydroxy-hautriwaic lactone (0.6 mg). The fraction B-3 was subjected to reverse phase HPLC (MN Isis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olumn, 5 </a:t>
            </a:r>
            <a:r>
              <a:rPr lang="en-US" sz="1050" kern="100" dirty="0"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m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, 250 x 4.6 mm,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eCN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/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 + 0.1%FA for each, 50-90%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eCN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) to give 1-deoxybacrispine (3 mg) and 18-dihydro-conyscabrafuran (0.9 mg). The latter, newly found in B.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acraei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, was named for its structural similarity to the seven-membered ring diterpenes found in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onyza </a:t>
            </a:r>
            <a:r>
              <a:rPr lang="en-US" sz="1050" i="1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scabrida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(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Bohlmann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, 1983). The fraction A-6 was further separated by silica gel flash column chromatography (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tOA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/Hexane, first; 0-35 %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tOA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, second; 0-50%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tOA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+ 0.2% FA) and reverse phase p-TLC (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eCN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/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 = 3: 2) to afford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autriwaic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acid (3 mg).</a:t>
            </a:r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pPr algn="just"/>
            <a:endParaRPr lang="en-US" sz="1050" kern="100" dirty="0">
              <a:solidFill>
                <a:srgbClr val="000000"/>
              </a:solidFill>
              <a:latin typeface="Calibri" panose="020F050202020403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pPr algn="just"/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pPr algn="just"/>
            <a:endParaRPr lang="en-JP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F6BD7A-1066-9CF9-6E3B-5D9FE9D23FAC}"/>
              </a:ext>
            </a:extLst>
          </p:cNvPr>
          <p:cNvSpPr txBox="1"/>
          <p:nvPr/>
        </p:nvSpPr>
        <p:spPr>
          <a:xfrm>
            <a:off x="303609" y="6044341"/>
            <a:ext cx="6250781" cy="4308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50000"/>
              </a:lnSpc>
            </a:pPr>
            <a:r>
              <a:rPr lang="en-CA" sz="1050" b="1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S2  HR-ESI-MS (high-resolution electrospray ionization mass spectrometry) data of the diterpenoids</a:t>
            </a:r>
            <a:endParaRPr lang="en-JP" sz="1200" dirty="0">
              <a:effectLst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623C5C-26EC-87D8-09F2-573D7BB15794}"/>
              </a:ext>
            </a:extLst>
          </p:cNvPr>
          <p:cNvSpPr txBox="1"/>
          <p:nvPr/>
        </p:nvSpPr>
        <p:spPr>
          <a:xfrm>
            <a:off x="303609" y="6648773"/>
            <a:ext cx="6500497" cy="24699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Bacchasmacranone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HRMS (ESI-TOF, positive)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/z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alc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for C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0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5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4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[M+H]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+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329.1747, found 329.1750. </a:t>
            </a:r>
          </a:p>
          <a:p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8-</a:t>
            </a:r>
            <a:r>
              <a:rPr lang="en-US" sz="1050" b="1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epi</a:t>
            </a:r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-bacchasmacranone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HRMS (ESI-TOF, positive)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/z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alc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for C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0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5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4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[M+H]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+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329.1747, found 329.1748. </a:t>
            </a:r>
          </a:p>
          <a:p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</a:t>
            </a:r>
            <a:r>
              <a:rPr lang="en-US" sz="1050" b="1" kern="100" dirty="0">
                <a:effectLst/>
                <a:latin typeface="Symbol" pitchFamily="2" charset="2"/>
                <a:ea typeface="Yu Gothic" panose="020B0400000000000000" pitchFamily="34" charset="-128"/>
                <a:cs typeface="Calibri" panose="020F0502020204030204" pitchFamily="34" charset="0"/>
              </a:rPr>
              <a:t>b</a:t>
            </a:r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-hydroxy-hautriwaic lactone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HRMS (ESI-TOF, positive)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/z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alc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for C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0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7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4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[M+H]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+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331.1904, found 331.1903.</a:t>
            </a:r>
          </a:p>
          <a:p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1-deoxybacrispine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HRMS (ESI-TOF, positive)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/z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alc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for C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0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7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4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[M+H]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+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331.1904, found 331.1904. </a:t>
            </a:r>
          </a:p>
          <a:p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18-dihydro-conyscabrafuran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HRMS (ESI-TOF, positive)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/z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alc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for C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0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9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[M+H]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+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301.2162, found 301.2162. </a:t>
            </a:r>
          </a:p>
          <a:p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r>
              <a:rPr lang="en-US" sz="1050" b="1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autriwaic</a:t>
            </a:r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aci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HRMS (ESI-TOF, positive)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/z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alc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for C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0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9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4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[M+H]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+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333.2060, found 333.2061. </a:t>
            </a:r>
          </a:p>
          <a:p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r>
              <a:rPr lang="en-US" sz="1050" b="1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ardwickiic</a:t>
            </a:r>
            <a:r>
              <a:rPr lang="en-US" sz="1050" b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aci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HRMS (ESI-TOF, positive) </a:t>
            </a:r>
            <a:r>
              <a:rPr lang="en-US" sz="1050" i="1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/z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: </a:t>
            </a:r>
            <a:r>
              <a:rPr lang="en-US" sz="1050" kern="100" dirty="0" err="1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calcd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for C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0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29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O</a:t>
            </a:r>
            <a:r>
              <a:rPr lang="en-US" sz="1050" kern="100" baseline="-25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3 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[M+H]</a:t>
            </a:r>
            <a:r>
              <a:rPr lang="en-US" sz="1050" kern="100" baseline="300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+</a:t>
            </a:r>
            <a:r>
              <a:rPr lang="en-US" sz="1050" kern="100" dirty="0">
                <a:effectLst/>
                <a:latin typeface="Calibri" panose="020F050202020403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317.2111, found 317.2117. </a:t>
            </a:r>
            <a:endParaRPr lang="en-JP" sz="1050" kern="100" dirty="0">
              <a:effectLst/>
              <a:latin typeface="Aptos" panose="020B0004020202020204" pitchFamily="34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endParaRPr lang="en-JP" dirty="0"/>
          </a:p>
        </p:txBody>
      </p:sp>
    </p:spTree>
    <p:extLst>
      <p:ext uri="{BB962C8B-B14F-4D97-AF65-F5344CB8AC3E}">
        <p14:creationId xmlns:p14="http://schemas.microsoft.com/office/powerpoint/2010/main" val="451799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53">
            <a:extLst>
              <a:ext uri="{FF2B5EF4-FFF2-40B4-BE49-F238E27FC236}">
                <a16:creationId xmlns:a16="http://schemas.microsoft.com/office/drawing/2014/main" id="{125ADA37-E0CA-46DE-B31C-7E60EB33B4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399" y="1302084"/>
            <a:ext cx="1193597" cy="195133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96344" y="118973"/>
            <a:ext cx="27574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200" b="1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S3  NMR assignment of the diterpenoids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BEAC4F4-87FC-4AAF-9B61-74A224EEC44E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504999676"/>
              </p:ext>
            </p:extLst>
          </p:nvPr>
        </p:nvGraphicFramePr>
        <p:xfrm>
          <a:off x="3023137" y="806637"/>
          <a:ext cx="3307817" cy="3545166"/>
        </p:xfrm>
        <a:graphic>
          <a:graphicData uri="http://schemas.openxmlformats.org/drawingml/2006/table">
            <a:tbl>
              <a:tblPr/>
              <a:tblGrid>
                <a:gridCol w="571508">
                  <a:extLst>
                    <a:ext uri="{9D8B030D-6E8A-4147-A177-3AD203B41FA5}">
                      <a16:colId xmlns:a16="http://schemas.microsoft.com/office/drawing/2014/main" val="4278298976"/>
                    </a:ext>
                  </a:extLst>
                </a:gridCol>
                <a:gridCol w="571508">
                  <a:extLst>
                    <a:ext uri="{9D8B030D-6E8A-4147-A177-3AD203B41FA5}">
                      <a16:colId xmlns:a16="http://schemas.microsoft.com/office/drawing/2014/main" val="707014732"/>
                    </a:ext>
                  </a:extLst>
                </a:gridCol>
                <a:gridCol w="571508">
                  <a:extLst>
                    <a:ext uri="{9D8B030D-6E8A-4147-A177-3AD203B41FA5}">
                      <a16:colId xmlns:a16="http://schemas.microsoft.com/office/drawing/2014/main" val="284156190"/>
                    </a:ext>
                  </a:extLst>
                </a:gridCol>
                <a:gridCol w="912025">
                  <a:extLst>
                    <a:ext uri="{9D8B030D-6E8A-4147-A177-3AD203B41FA5}">
                      <a16:colId xmlns:a16="http://schemas.microsoft.com/office/drawing/2014/main" val="2598732499"/>
                    </a:ext>
                  </a:extLst>
                </a:gridCol>
                <a:gridCol w="681268">
                  <a:extLst>
                    <a:ext uri="{9D8B030D-6E8A-4147-A177-3AD203B41FA5}">
                      <a16:colId xmlns:a16="http://schemas.microsoft.com/office/drawing/2014/main" val="2760295123"/>
                    </a:ext>
                  </a:extLst>
                </a:gridCol>
              </a:tblGrid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.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.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5663186"/>
                  </a:ext>
                </a:extLst>
              </a:tr>
              <a:tr h="13834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4/12.4/12.4/3.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8743133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7078921"/>
                  </a:ext>
                </a:extLst>
              </a:tr>
              <a:tr h="1334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1/7.5/3.9/2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6909905"/>
                  </a:ext>
                </a:extLst>
              </a:tr>
              <a:tr h="7711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1/11.6/4.6/2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4172535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/2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.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7627688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6.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268256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1121305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7406849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6324581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9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5087914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7332966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3796224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1791524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a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/12.4/4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0038449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b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/12.6/4.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8003671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a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7136867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b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687327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8559723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2143226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/1.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7115158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9570254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9404764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8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4608339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4/2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3833324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947707"/>
                  </a:ext>
                </a:extLst>
              </a:tr>
              <a:tr h="1150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1430462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E2BE0E75-D569-46CB-91DA-CF835A85E819}"/>
              </a:ext>
            </a:extLst>
          </p:cNvPr>
          <p:cNvSpPr txBox="1"/>
          <p:nvPr/>
        </p:nvSpPr>
        <p:spPr>
          <a:xfrm>
            <a:off x="2961168" y="4351803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700 MHz in CDCl</a:t>
            </a:r>
            <a:r>
              <a:rPr lang="en-US" sz="800" baseline="-25000" dirty="0"/>
              <a:t>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29266ED-2321-4A18-94A4-8C9CA986F1C9}"/>
              </a:ext>
            </a:extLst>
          </p:cNvPr>
          <p:cNvSpPr txBox="1"/>
          <p:nvPr/>
        </p:nvSpPr>
        <p:spPr>
          <a:xfrm>
            <a:off x="2950151" y="4498232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*overlapped signals </a:t>
            </a:r>
            <a:r>
              <a:rPr lang="en-US" sz="800" i="1" dirty="0"/>
              <a:t>J </a:t>
            </a:r>
            <a:r>
              <a:rPr lang="en-US" sz="800" dirty="0"/>
              <a:t>unresolve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E63D271-1F89-49C2-A823-349CC5A6C986}"/>
              </a:ext>
            </a:extLst>
          </p:cNvPr>
          <p:cNvSpPr txBox="1"/>
          <p:nvPr/>
        </p:nvSpPr>
        <p:spPr>
          <a:xfrm>
            <a:off x="2961168" y="4631754"/>
            <a:ext cx="360526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The chemical shifts were in agreement with published data (Gambaro </a:t>
            </a:r>
            <a:r>
              <a:rPr lang="en-US" sz="800" i="1" dirty="0"/>
              <a:t>et al</a:t>
            </a:r>
            <a:r>
              <a:rPr lang="en-US" sz="800" dirty="0"/>
              <a:t>. 1986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BDF375F-932D-4D54-A76D-87746230B937}"/>
              </a:ext>
            </a:extLst>
          </p:cNvPr>
          <p:cNvSpPr txBox="1"/>
          <p:nvPr/>
        </p:nvSpPr>
        <p:spPr>
          <a:xfrm>
            <a:off x="572503" y="229210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CDA0AA8-B83A-42AC-9007-C8301393FB62}"/>
              </a:ext>
            </a:extLst>
          </p:cNvPr>
          <p:cNvSpPr txBox="1"/>
          <p:nvPr/>
        </p:nvSpPr>
        <p:spPr>
          <a:xfrm>
            <a:off x="1111778" y="254057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E563528-4D4D-4B80-81AF-B184644ABAE4}"/>
              </a:ext>
            </a:extLst>
          </p:cNvPr>
          <p:cNvSpPr txBox="1"/>
          <p:nvPr/>
        </p:nvSpPr>
        <p:spPr>
          <a:xfrm>
            <a:off x="561486" y="255159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A4A189F-06E3-4CF4-ACA3-2DE8B5CFBBEB}"/>
              </a:ext>
            </a:extLst>
          </p:cNvPr>
          <p:cNvSpPr txBox="1"/>
          <p:nvPr/>
        </p:nvSpPr>
        <p:spPr>
          <a:xfrm>
            <a:off x="833805" y="21599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B9AC76D-82E7-4FAC-8DE2-4958BAD3F13D}"/>
              </a:ext>
            </a:extLst>
          </p:cNvPr>
          <p:cNvSpPr txBox="1"/>
          <p:nvPr/>
        </p:nvSpPr>
        <p:spPr>
          <a:xfrm>
            <a:off x="1383018" y="254727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8DC5643-7782-4517-BAA3-40311C0F88B0}"/>
              </a:ext>
            </a:extLst>
          </p:cNvPr>
          <p:cNvSpPr txBox="1"/>
          <p:nvPr/>
        </p:nvSpPr>
        <p:spPr>
          <a:xfrm>
            <a:off x="1460356" y="226762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A1243DB-976D-4E76-B484-A6F9E58DE021}"/>
              </a:ext>
            </a:extLst>
          </p:cNvPr>
          <p:cNvSpPr txBox="1"/>
          <p:nvPr/>
        </p:nvSpPr>
        <p:spPr>
          <a:xfrm>
            <a:off x="1187797" y="191888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313071-8143-4051-B543-83B344EC2F4F}"/>
              </a:ext>
            </a:extLst>
          </p:cNvPr>
          <p:cNvSpPr txBox="1"/>
          <p:nvPr/>
        </p:nvSpPr>
        <p:spPr>
          <a:xfrm>
            <a:off x="1500999" y="166979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15818DB-7439-4C99-888D-FEDC0BF6360E}"/>
              </a:ext>
            </a:extLst>
          </p:cNvPr>
          <p:cNvSpPr txBox="1"/>
          <p:nvPr/>
        </p:nvSpPr>
        <p:spPr>
          <a:xfrm>
            <a:off x="1150566" y="143631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8A7C9BC-7F18-4B28-AC00-6CB75DEE6F38}"/>
              </a:ext>
            </a:extLst>
          </p:cNvPr>
          <p:cNvSpPr txBox="1"/>
          <p:nvPr/>
        </p:nvSpPr>
        <p:spPr>
          <a:xfrm>
            <a:off x="1270213" y="121508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B8826B2-E066-41B7-BE44-BF092E8FCE30}"/>
              </a:ext>
            </a:extLst>
          </p:cNvPr>
          <p:cNvSpPr txBox="1"/>
          <p:nvPr/>
        </p:nvSpPr>
        <p:spPr>
          <a:xfrm>
            <a:off x="1713541" y="149786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8D26A6E-4BDD-4A11-8E02-AEC35D8D5DFE}"/>
              </a:ext>
            </a:extLst>
          </p:cNvPr>
          <p:cNvSpPr txBox="1"/>
          <p:nvPr/>
        </p:nvSpPr>
        <p:spPr>
          <a:xfrm>
            <a:off x="1757037" y="222429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463C1C8-83AB-4502-A48D-6AE53FF106E2}"/>
              </a:ext>
            </a:extLst>
          </p:cNvPr>
          <p:cNvSpPr txBox="1"/>
          <p:nvPr/>
        </p:nvSpPr>
        <p:spPr>
          <a:xfrm>
            <a:off x="1516024" y="205716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DDFF0CC-0916-4294-9066-B74F7D1D0FFF}"/>
              </a:ext>
            </a:extLst>
          </p:cNvPr>
          <p:cNvSpPr txBox="1"/>
          <p:nvPr/>
        </p:nvSpPr>
        <p:spPr>
          <a:xfrm>
            <a:off x="1229759" y="286369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9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135244F-65F4-4BC1-9332-DAA891F189A0}"/>
              </a:ext>
            </a:extLst>
          </p:cNvPr>
          <p:cNvSpPr txBox="1"/>
          <p:nvPr/>
        </p:nvSpPr>
        <p:spPr>
          <a:xfrm>
            <a:off x="784502" y="302730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57CB7FB-7A0B-4B67-92E5-6BB84C446B0B}"/>
              </a:ext>
            </a:extLst>
          </p:cNvPr>
          <p:cNvSpPr txBox="1"/>
          <p:nvPr/>
        </p:nvSpPr>
        <p:spPr>
          <a:xfrm>
            <a:off x="1111778" y="237453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C7204C0E-C78E-473A-B5D8-ACE41C2CAB4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311" y="6317440"/>
            <a:ext cx="1193597" cy="1951330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B6D965CF-A0AD-4865-B95F-ABCA3BC3067F}"/>
              </a:ext>
            </a:extLst>
          </p:cNvPr>
          <p:cNvSpPr/>
          <p:nvPr/>
        </p:nvSpPr>
        <p:spPr>
          <a:xfrm>
            <a:off x="96344" y="5407566"/>
            <a:ext cx="296908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3-2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dat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8-</a:t>
            </a:r>
            <a:r>
              <a:rPr lang="de-DE" sz="1200" i="1" dirty="0">
                <a:ea typeface="MS Mincho"/>
              </a:rPr>
              <a:t>epi</a:t>
            </a:r>
            <a:r>
              <a:rPr lang="de-DE" sz="1200" dirty="0">
                <a:ea typeface="MS Mincho"/>
              </a:rPr>
              <a:t>-</a:t>
            </a:r>
            <a:r>
              <a:rPr lang="en-US" sz="1200" dirty="0" err="1"/>
              <a:t>bacchasmacranone</a:t>
            </a:r>
            <a:endParaRPr lang="en-US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648B24C-1A93-4941-88E7-2CB9E1AD3EAD}"/>
              </a:ext>
            </a:extLst>
          </p:cNvPr>
          <p:cNvSpPr txBox="1"/>
          <p:nvPr/>
        </p:nvSpPr>
        <p:spPr>
          <a:xfrm>
            <a:off x="572503" y="732674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10E1CF2-728C-44D3-8AB0-4FE47173BDA2}"/>
              </a:ext>
            </a:extLst>
          </p:cNvPr>
          <p:cNvSpPr txBox="1"/>
          <p:nvPr/>
        </p:nvSpPr>
        <p:spPr>
          <a:xfrm>
            <a:off x="1111778" y="757521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2CCB0AB-7445-42A3-9D4B-3D7EAF838CEF}"/>
              </a:ext>
            </a:extLst>
          </p:cNvPr>
          <p:cNvSpPr txBox="1"/>
          <p:nvPr/>
        </p:nvSpPr>
        <p:spPr>
          <a:xfrm>
            <a:off x="561486" y="758623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528D0C2-FFF7-4958-9B0E-85A0AFCB6086}"/>
              </a:ext>
            </a:extLst>
          </p:cNvPr>
          <p:cNvSpPr txBox="1"/>
          <p:nvPr/>
        </p:nvSpPr>
        <p:spPr>
          <a:xfrm>
            <a:off x="833805" y="71945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ED22F77-41BA-479C-9759-E9C3501AB038}"/>
              </a:ext>
            </a:extLst>
          </p:cNvPr>
          <p:cNvSpPr txBox="1"/>
          <p:nvPr/>
        </p:nvSpPr>
        <p:spPr>
          <a:xfrm>
            <a:off x="1383018" y="758191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7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5587B4F-15DB-4288-BF68-D7B14AB8E606}"/>
              </a:ext>
            </a:extLst>
          </p:cNvPr>
          <p:cNvSpPr txBox="1"/>
          <p:nvPr/>
        </p:nvSpPr>
        <p:spPr>
          <a:xfrm>
            <a:off x="1460356" y="73022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5848A17-1C28-4CE7-8DB5-A259536408AF}"/>
              </a:ext>
            </a:extLst>
          </p:cNvPr>
          <p:cNvSpPr txBox="1"/>
          <p:nvPr/>
        </p:nvSpPr>
        <p:spPr>
          <a:xfrm>
            <a:off x="1187797" y="695352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DB22644-2323-44EE-9FEF-FCE85237FB8D}"/>
              </a:ext>
            </a:extLst>
          </p:cNvPr>
          <p:cNvSpPr txBox="1"/>
          <p:nvPr/>
        </p:nvSpPr>
        <p:spPr>
          <a:xfrm>
            <a:off x="1500999" y="67044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9E4B752-4F18-4FB1-8647-8E10FF2DACE5}"/>
              </a:ext>
            </a:extLst>
          </p:cNvPr>
          <p:cNvSpPr txBox="1"/>
          <p:nvPr/>
        </p:nvSpPr>
        <p:spPr>
          <a:xfrm>
            <a:off x="1150566" y="647095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4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2E9C1A2-C59C-4B6B-AAC7-CB75AECC76B7}"/>
              </a:ext>
            </a:extLst>
          </p:cNvPr>
          <p:cNvSpPr txBox="1"/>
          <p:nvPr/>
        </p:nvSpPr>
        <p:spPr>
          <a:xfrm>
            <a:off x="1270213" y="624973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C7C389A-03A8-4578-84AF-DCF7BACF9E5E}"/>
              </a:ext>
            </a:extLst>
          </p:cNvPr>
          <p:cNvSpPr txBox="1"/>
          <p:nvPr/>
        </p:nvSpPr>
        <p:spPr>
          <a:xfrm>
            <a:off x="1713541" y="653250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04F6168-05D6-45F5-B27D-15CE7BEC6696}"/>
              </a:ext>
            </a:extLst>
          </p:cNvPr>
          <p:cNvSpPr txBox="1"/>
          <p:nvPr/>
        </p:nvSpPr>
        <p:spPr>
          <a:xfrm>
            <a:off x="1757037" y="72589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7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DB08E09-C91C-40D6-AA77-E707739A2310}"/>
              </a:ext>
            </a:extLst>
          </p:cNvPr>
          <p:cNvSpPr txBox="1"/>
          <p:nvPr/>
        </p:nvSpPr>
        <p:spPr>
          <a:xfrm>
            <a:off x="1516024" y="709180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BEB70E5-961E-487E-BA46-4C39C9F3B217}"/>
              </a:ext>
            </a:extLst>
          </p:cNvPr>
          <p:cNvSpPr txBox="1"/>
          <p:nvPr/>
        </p:nvSpPr>
        <p:spPr>
          <a:xfrm>
            <a:off x="1229759" y="789833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C342C89-8906-47B1-AFF2-BE7391A4CCCC}"/>
              </a:ext>
            </a:extLst>
          </p:cNvPr>
          <p:cNvSpPr txBox="1"/>
          <p:nvPr/>
        </p:nvSpPr>
        <p:spPr>
          <a:xfrm>
            <a:off x="784502" y="806195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8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9F3938A-0CB1-47FD-A342-DA4E308864AD}"/>
              </a:ext>
            </a:extLst>
          </p:cNvPr>
          <p:cNvSpPr txBox="1"/>
          <p:nvPr/>
        </p:nvSpPr>
        <p:spPr>
          <a:xfrm>
            <a:off x="1111778" y="740917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</a:t>
            </a:r>
          </a:p>
        </p:txBody>
      </p:sp>
      <p:graphicFrame>
        <p:nvGraphicFramePr>
          <p:cNvPr id="51" name="Table 50">
            <a:extLst>
              <a:ext uri="{FF2B5EF4-FFF2-40B4-BE49-F238E27FC236}">
                <a16:creationId xmlns:a16="http://schemas.microsoft.com/office/drawing/2014/main" id="{CE330BA0-BA83-4AFD-A44D-B1364DE9E6B5}"/>
              </a:ext>
            </a:extLst>
          </p:cNvPr>
          <p:cNvGraphicFramePr>
            <a:graphicFrameLocks noGrp="1"/>
          </p:cNvGraphicFramePr>
          <p:nvPr/>
        </p:nvGraphicFramePr>
        <p:xfrm>
          <a:off x="3045029" y="5747989"/>
          <a:ext cx="3191772" cy="3745283"/>
        </p:xfrm>
        <a:graphic>
          <a:graphicData uri="http://schemas.openxmlformats.org/drawingml/2006/table">
            <a:tbl>
              <a:tblPr/>
              <a:tblGrid>
                <a:gridCol w="522722">
                  <a:extLst>
                    <a:ext uri="{9D8B030D-6E8A-4147-A177-3AD203B41FA5}">
                      <a16:colId xmlns:a16="http://schemas.microsoft.com/office/drawing/2014/main" val="1719631251"/>
                    </a:ext>
                  </a:extLst>
                </a:gridCol>
                <a:gridCol w="522722">
                  <a:extLst>
                    <a:ext uri="{9D8B030D-6E8A-4147-A177-3AD203B41FA5}">
                      <a16:colId xmlns:a16="http://schemas.microsoft.com/office/drawing/2014/main" val="4040455816"/>
                    </a:ext>
                  </a:extLst>
                </a:gridCol>
                <a:gridCol w="522722">
                  <a:extLst>
                    <a:ext uri="{9D8B030D-6E8A-4147-A177-3AD203B41FA5}">
                      <a16:colId xmlns:a16="http://schemas.microsoft.com/office/drawing/2014/main" val="2858185373"/>
                    </a:ext>
                  </a:extLst>
                </a:gridCol>
                <a:gridCol w="974164">
                  <a:extLst>
                    <a:ext uri="{9D8B030D-6E8A-4147-A177-3AD203B41FA5}">
                      <a16:colId xmlns:a16="http://schemas.microsoft.com/office/drawing/2014/main" val="1075155716"/>
                    </a:ext>
                  </a:extLst>
                </a:gridCol>
                <a:gridCol w="649442">
                  <a:extLst>
                    <a:ext uri="{9D8B030D-6E8A-4147-A177-3AD203B41FA5}">
                      <a16:colId xmlns:a16="http://schemas.microsoft.com/office/drawing/2014/main" val="3356659421"/>
                    </a:ext>
                  </a:extLst>
                </a:gridCol>
              </a:tblGrid>
              <a:tr h="13784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.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.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1997064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/12.5/12.5/3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9568170"/>
                  </a:ext>
                </a:extLst>
              </a:tr>
              <a:tr h="131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024204"/>
                  </a:ext>
                </a:extLst>
              </a:tr>
              <a:tr h="133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1/7.5/3.7/2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6896386"/>
                  </a:ext>
                </a:extLst>
              </a:tr>
              <a:tr h="1484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864088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/1.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1571335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5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414392"/>
                  </a:ext>
                </a:extLst>
              </a:tr>
              <a:tr h="131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123157"/>
                  </a:ext>
                </a:extLst>
              </a:tr>
              <a:tr h="1484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1146431"/>
                  </a:ext>
                </a:extLst>
              </a:tr>
              <a:tr h="133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5/2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3198202"/>
                  </a:ext>
                </a:extLst>
              </a:tr>
              <a:tr h="133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1.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3209666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2894956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8047131"/>
                  </a:ext>
                </a:extLst>
              </a:tr>
              <a:tr h="1484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6384245"/>
                  </a:ext>
                </a:extLst>
              </a:tr>
              <a:tr h="1484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a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90033"/>
                  </a:ext>
                </a:extLst>
              </a:tr>
              <a:tr h="9714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b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4504573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a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2842879"/>
                  </a:ext>
                </a:extLst>
              </a:tr>
              <a:tr h="133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b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2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6725975"/>
                  </a:ext>
                </a:extLst>
              </a:tr>
              <a:tr h="133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3559807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3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.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720396"/>
                  </a:ext>
                </a:extLst>
              </a:tr>
              <a:tr h="1484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70479"/>
                  </a:ext>
                </a:extLst>
              </a:tr>
              <a:tr h="133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6582106"/>
                  </a:ext>
                </a:extLst>
              </a:tr>
              <a:tr h="133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2693761"/>
                  </a:ext>
                </a:extLst>
              </a:tr>
              <a:tr h="131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8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7220828"/>
                  </a:ext>
                </a:extLst>
              </a:tr>
              <a:tr h="1420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/2.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9493148"/>
                  </a:ext>
                </a:extLst>
              </a:tr>
              <a:tr h="131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1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4243783"/>
                  </a:ext>
                </a:extLst>
              </a:tr>
              <a:tr h="1319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5</a:t>
                      </a:r>
                    </a:p>
                  </a:txBody>
                  <a:tcPr marL="9014" marR="9014" marT="9014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4223528"/>
                  </a:ext>
                </a:extLst>
              </a:tr>
            </a:tbl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D43C2DAD-CAA6-40A7-9A13-85584A123ACE}"/>
              </a:ext>
            </a:extLst>
          </p:cNvPr>
          <p:cNvSpPr txBox="1"/>
          <p:nvPr/>
        </p:nvSpPr>
        <p:spPr>
          <a:xfrm>
            <a:off x="2961168" y="9493272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700 MHz in CDCl</a:t>
            </a:r>
            <a:r>
              <a:rPr lang="en-US" sz="800" baseline="-25000" dirty="0"/>
              <a:t>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9B6354E-5370-40F4-BEF6-B7DE74D558B4}"/>
              </a:ext>
            </a:extLst>
          </p:cNvPr>
          <p:cNvSpPr txBox="1"/>
          <p:nvPr/>
        </p:nvSpPr>
        <p:spPr>
          <a:xfrm>
            <a:off x="2950151" y="9624203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*overlapped signals </a:t>
            </a:r>
            <a:r>
              <a:rPr lang="en-US" sz="800" i="1" dirty="0"/>
              <a:t>J </a:t>
            </a:r>
            <a:r>
              <a:rPr lang="en-US" sz="800" dirty="0"/>
              <a:t>unresolve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B3406D-E61F-27CC-A776-F9BDF1134585}"/>
              </a:ext>
            </a:extLst>
          </p:cNvPr>
          <p:cNvSpPr txBox="1"/>
          <p:nvPr/>
        </p:nvSpPr>
        <p:spPr>
          <a:xfrm>
            <a:off x="96344" y="490091"/>
            <a:ext cx="403343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b="1" dirty="0">
                <a:ea typeface="MS Mincho"/>
              </a:rPr>
              <a:t>S3-1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dat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 err="1"/>
              <a:t>bacchasmacranone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650125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38970" y="153483"/>
            <a:ext cx="3303277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3-3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dat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2</a:t>
            </a:r>
            <a:r>
              <a:rPr lang="en-US" sz="1200" dirty="0">
                <a:latin typeface="Symbol" panose="05050102010706020507" pitchFamily="18" charset="2"/>
              </a:rPr>
              <a:t>b</a:t>
            </a:r>
            <a:r>
              <a:rPr lang="en-US" sz="1200" dirty="0"/>
              <a:t>-hydroxy-hautriwaic lactone</a:t>
            </a:r>
          </a:p>
          <a:p>
            <a:endParaRPr lang="en-US" sz="1400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72D1D60-955B-476C-9982-DCAC5717B51D}"/>
              </a:ext>
            </a:extLst>
          </p:cNvPr>
          <p:cNvGraphicFramePr>
            <a:graphicFrameLocks noGrp="1"/>
          </p:cNvGraphicFramePr>
          <p:nvPr/>
        </p:nvGraphicFramePr>
        <p:xfrm>
          <a:off x="3121479" y="423369"/>
          <a:ext cx="3171933" cy="3998528"/>
        </p:xfrm>
        <a:graphic>
          <a:graphicData uri="http://schemas.openxmlformats.org/drawingml/2006/table">
            <a:tbl>
              <a:tblPr/>
              <a:tblGrid>
                <a:gridCol w="558260">
                  <a:extLst>
                    <a:ext uri="{9D8B030D-6E8A-4147-A177-3AD203B41FA5}">
                      <a16:colId xmlns:a16="http://schemas.microsoft.com/office/drawing/2014/main" val="2325604494"/>
                    </a:ext>
                  </a:extLst>
                </a:gridCol>
                <a:gridCol w="558260">
                  <a:extLst>
                    <a:ext uri="{9D8B030D-6E8A-4147-A177-3AD203B41FA5}">
                      <a16:colId xmlns:a16="http://schemas.microsoft.com/office/drawing/2014/main" val="1745683958"/>
                    </a:ext>
                  </a:extLst>
                </a:gridCol>
                <a:gridCol w="558260">
                  <a:extLst>
                    <a:ext uri="{9D8B030D-6E8A-4147-A177-3AD203B41FA5}">
                      <a16:colId xmlns:a16="http://schemas.microsoft.com/office/drawing/2014/main" val="2166254716"/>
                    </a:ext>
                  </a:extLst>
                </a:gridCol>
                <a:gridCol w="938893">
                  <a:extLst>
                    <a:ext uri="{9D8B030D-6E8A-4147-A177-3AD203B41FA5}">
                      <a16:colId xmlns:a16="http://schemas.microsoft.com/office/drawing/2014/main" val="1419646813"/>
                    </a:ext>
                  </a:extLst>
                </a:gridCol>
                <a:gridCol w="558260">
                  <a:extLst>
                    <a:ext uri="{9D8B030D-6E8A-4147-A177-3AD203B41FA5}">
                      <a16:colId xmlns:a16="http://schemas.microsoft.com/office/drawing/2014/main" val="3444387718"/>
                    </a:ext>
                  </a:extLst>
                </a:gridCol>
              </a:tblGrid>
              <a:tr h="16699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1569126"/>
                  </a:ext>
                </a:extLst>
              </a:tr>
              <a:tr h="1721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5/2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2510570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5140496"/>
                  </a:ext>
                </a:extLst>
              </a:tr>
              <a:tr h="1721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3987067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7954276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9050386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3711873"/>
                  </a:ext>
                </a:extLst>
              </a:tr>
              <a:tr h="16228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/3.3/3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9583194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4311381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3073022"/>
                  </a:ext>
                </a:extLst>
              </a:tr>
              <a:tr h="146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/6.8/3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3294799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7756704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2738542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5970902"/>
                  </a:ext>
                </a:extLst>
              </a:tr>
              <a:tr h="1721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2012540"/>
                  </a:ext>
                </a:extLst>
              </a:tr>
              <a:tr h="16228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1962993"/>
                  </a:ext>
                </a:extLst>
              </a:tr>
              <a:tr h="154151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9/4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3725955"/>
                  </a:ext>
                </a:extLst>
              </a:tr>
              <a:tr h="1464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4/4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8755048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9292786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7123233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/1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7814672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1680992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7698789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9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33993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/1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7927084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3295451"/>
                  </a:ext>
                </a:extLst>
              </a:tr>
              <a:tr h="14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9915044"/>
                  </a:ext>
                </a:extLst>
              </a:tr>
            </a:tbl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03F7CE2A-E5E6-4F0E-944F-4CB1378B23C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88" y="1393397"/>
            <a:ext cx="1460144" cy="195133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24D3476-D4EE-4847-A0A2-F70D722052AE}"/>
              </a:ext>
            </a:extLst>
          </p:cNvPr>
          <p:cNvSpPr txBox="1"/>
          <p:nvPr/>
        </p:nvSpPr>
        <p:spPr>
          <a:xfrm>
            <a:off x="833762" y="234192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4961E9C-39AF-42F1-805B-E732FAB76B6F}"/>
              </a:ext>
            </a:extLst>
          </p:cNvPr>
          <p:cNvSpPr txBox="1"/>
          <p:nvPr/>
        </p:nvSpPr>
        <p:spPr>
          <a:xfrm>
            <a:off x="1324050" y="26557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3914C63-F1C9-4E7D-B7FE-11E97B6BDFE1}"/>
              </a:ext>
            </a:extLst>
          </p:cNvPr>
          <p:cNvSpPr txBox="1"/>
          <p:nvPr/>
        </p:nvSpPr>
        <p:spPr>
          <a:xfrm>
            <a:off x="773758" y="26667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F2A0A04-0C32-40F6-8481-42C66AECF74B}"/>
              </a:ext>
            </a:extLst>
          </p:cNvPr>
          <p:cNvSpPr txBox="1"/>
          <p:nvPr/>
        </p:nvSpPr>
        <p:spPr>
          <a:xfrm>
            <a:off x="1046077" y="227503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E69863A-0D56-43B4-B862-8644A00FBC9F}"/>
              </a:ext>
            </a:extLst>
          </p:cNvPr>
          <p:cNvSpPr txBox="1"/>
          <p:nvPr/>
        </p:nvSpPr>
        <p:spPr>
          <a:xfrm>
            <a:off x="1595290" y="266240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B362A35-A166-4198-8468-6559D2EAD208}"/>
              </a:ext>
            </a:extLst>
          </p:cNvPr>
          <p:cNvSpPr txBox="1"/>
          <p:nvPr/>
        </p:nvSpPr>
        <p:spPr>
          <a:xfrm>
            <a:off x="1672628" y="235009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CE7EC0C-2CFE-4376-86E3-7F0AD5504742}"/>
              </a:ext>
            </a:extLst>
          </p:cNvPr>
          <p:cNvSpPr txBox="1"/>
          <p:nvPr/>
        </p:nvSpPr>
        <p:spPr>
          <a:xfrm>
            <a:off x="1400069" y="203401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4126410-F68A-4A51-A454-1B3276F9E0C4}"/>
              </a:ext>
            </a:extLst>
          </p:cNvPr>
          <p:cNvSpPr txBox="1"/>
          <p:nvPr/>
        </p:nvSpPr>
        <p:spPr>
          <a:xfrm>
            <a:off x="1713271" y="17849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227129B-9F37-4E32-9037-90B2A6DF4D38}"/>
              </a:ext>
            </a:extLst>
          </p:cNvPr>
          <p:cNvSpPr txBox="1"/>
          <p:nvPr/>
        </p:nvSpPr>
        <p:spPr>
          <a:xfrm>
            <a:off x="1362838" y="155144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F2D8B4F-C120-4B4D-A8EF-2206DE0B1ED0}"/>
              </a:ext>
            </a:extLst>
          </p:cNvPr>
          <p:cNvSpPr txBox="1"/>
          <p:nvPr/>
        </p:nvSpPr>
        <p:spPr>
          <a:xfrm>
            <a:off x="1482485" y="133022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E969B5D-94B8-4BC6-923C-787B25A18F87}"/>
              </a:ext>
            </a:extLst>
          </p:cNvPr>
          <p:cNvSpPr txBox="1"/>
          <p:nvPr/>
        </p:nvSpPr>
        <p:spPr>
          <a:xfrm>
            <a:off x="1925813" y="161299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984B7E-8C25-4D1C-A5F5-F60564B3D707}"/>
              </a:ext>
            </a:extLst>
          </p:cNvPr>
          <p:cNvSpPr txBox="1"/>
          <p:nvPr/>
        </p:nvSpPr>
        <p:spPr>
          <a:xfrm>
            <a:off x="1969309" y="23394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3908861-5D0E-4332-AA54-6DB3152CCC1B}"/>
              </a:ext>
            </a:extLst>
          </p:cNvPr>
          <p:cNvSpPr txBox="1"/>
          <p:nvPr/>
        </p:nvSpPr>
        <p:spPr>
          <a:xfrm>
            <a:off x="1728296" y="217229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7BF6A14-E640-49CD-B191-8208BDD50DE6}"/>
              </a:ext>
            </a:extLst>
          </p:cNvPr>
          <p:cNvSpPr txBox="1"/>
          <p:nvPr/>
        </p:nvSpPr>
        <p:spPr>
          <a:xfrm>
            <a:off x="1442031" y="297882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9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13A2C90-7678-4682-BC16-08E419E81103}"/>
              </a:ext>
            </a:extLst>
          </p:cNvPr>
          <p:cNvSpPr txBox="1"/>
          <p:nvPr/>
        </p:nvSpPr>
        <p:spPr>
          <a:xfrm>
            <a:off x="996774" y="314244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E592F8F-ECA3-462A-A573-C79F2AE9DDAC}"/>
              </a:ext>
            </a:extLst>
          </p:cNvPr>
          <p:cNvSpPr txBox="1"/>
          <p:nvPr/>
        </p:nvSpPr>
        <p:spPr>
          <a:xfrm>
            <a:off x="1324050" y="248966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7B4575F-F0D9-4E4B-96ED-0EA873EF3100}"/>
              </a:ext>
            </a:extLst>
          </p:cNvPr>
          <p:cNvSpPr/>
          <p:nvPr/>
        </p:nvSpPr>
        <p:spPr>
          <a:xfrm>
            <a:off x="141332" y="5383582"/>
            <a:ext cx="2542812" cy="67710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3-4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dat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/>
              <a:t>1-deoxybacrispine</a:t>
            </a:r>
          </a:p>
          <a:p>
            <a:r>
              <a:rPr lang="de-DE" sz="1200" dirty="0">
                <a:ea typeface="MS Mincho"/>
              </a:rPr>
              <a:t> </a:t>
            </a:r>
            <a:endParaRPr lang="en-US" sz="1200" dirty="0"/>
          </a:p>
          <a:p>
            <a:endParaRPr lang="en-US" sz="1400" dirty="0"/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271B51DE-4D89-4BDB-9550-5D91F05AA06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752" y="6498658"/>
            <a:ext cx="1294181" cy="195133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609918E9-F765-417C-853D-9A821FA3910B}"/>
              </a:ext>
            </a:extLst>
          </p:cNvPr>
          <p:cNvSpPr txBox="1"/>
          <p:nvPr/>
        </p:nvSpPr>
        <p:spPr>
          <a:xfrm>
            <a:off x="752117" y="746008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6D16887-2C08-4EA0-8908-B5E428EBA035}"/>
              </a:ext>
            </a:extLst>
          </p:cNvPr>
          <p:cNvSpPr txBox="1"/>
          <p:nvPr/>
        </p:nvSpPr>
        <p:spPr>
          <a:xfrm>
            <a:off x="1291392" y="77412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A0B6447-1374-40C1-B296-8D2822D75728}"/>
              </a:ext>
            </a:extLst>
          </p:cNvPr>
          <p:cNvSpPr txBox="1"/>
          <p:nvPr/>
        </p:nvSpPr>
        <p:spPr>
          <a:xfrm>
            <a:off x="741100" y="77522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8DA15F2-CD2F-4F66-BE6A-EE5B88350C64}"/>
              </a:ext>
            </a:extLst>
          </p:cNvPr>
          <p:cNvSpPr txBox="1"/>
          <p:nvPr/>
        </p:nvSpPr>
        <p:spPr>
          <a:xfrm>
            <a:off x="1013419" y="736053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FD43337-2AD6-4428-89D3-9B4FD151DC60}"/>
              </a:ext>
            </a:extLst>
          </p:cNvPr>
          <p:cNvSpPr txBox="1"/>
          <p:nvPr/>
        </p:nvSpPr>
        <p:spPr>
          <a:xfrm>
            <a:off x="1562632" y="774790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7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FC5A827-9D6F-4794-854E-63F7A263DAFF}"/>
              </a:ext>
            </a:extLst>
          </p:cNvPr>
          <p:cNvSpPr txBox="1"/>
          <p:nvPr/>
        </p:nvSpPr>
        <p:spPr>
          <a:xfrm>
            <a:off x="1639970" y="743559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5015D43-6FB8-4303-AECE-DAC26DF3D9BD}"/>
              </a:ext>
            </a:extLst>
          </p:cNvPr>
          <p:cNvSpPr txBox="1"/>
          <p:nvPr/>
        </p:nvSpPr>
        <p:spPr>
          <a:xfrm>
            <a:off x="1367411" y="711951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8F09143-138F-47A9-99E4-766612391B25}"/>
              </a:ext>
            </a:extLst>
          </p:cNvPr>
          <p:cNvSpPr txBox="1"/>
          <p:nvPr/>
        </p:nvSpPr>
        <p:spPr>
          <a:xfrm>
            <a:off x="1680613" y="68704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163EAEF-D126-4179-8442-573580C177F3}"/>
              </a:ext>
            </a:extLst>
          </p:cNvPr>
          <p:cNvSpPr txBox="1"/>
          <p:nvPr/>
        </p:nvSpPr>
        <p:spPr>
          <a:xfrm>
            <a:off x="1330180" y="663694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2CA75A0-6949-4847-8CCB-BB418D878340}"/>
              </a:ext>
            </a:extLst>
          </p:cNvPr>
          <p:cNvSpPr txBox="1"/>
          <p:nvPr/>
        </p:nvSpPr>
        <p:spPr>
          <a:xfrm>
            <a:off x="1449827" y="641572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6C9BA30-E438-4C04-88C4-3CF5F3BB8831}"/>
              </a:ext>
            </a:extLst>
          </p:cNvPr>
          <p:cNvSpPr txBox="1"/>
          <p:nvPr/>
        </p:nvSpPr>
        <p:spPr>
          <a:xfrm>
            <a:off x="1893155" y="669849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6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FCDA8B6-2BA1-4538-9CF7-C7575C8988F5}"/>
              </a:ext>
            </a:extLst>
          </p:cNvPr>
          <p:cNvSpPr txBox="1"/>
          <p:nvPr/>
        </p:nvSpPr>
        <p:spPr>
          <a:xfrm>
            <a:off x="1936651" y="74249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19BC3E4-66AB-46AF-B8F7-2B1591948532}"/>
              </a:ext>
            </a:extLst>
          </p:cNvPr>
          <p:cNvSpPr txBox="1"/>
          <p:nvPr/>
        </p:nvSpPr>
        <p:spPr>
          <a:xfrm>
            <a:off x="1695638" y="725779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D2A74C3-3071-4087-A9D2-D87429B42D55}"/>
              </a:ext>
            </a:extLst>
          </p:cNvPr>
          <p:cNvSpPr txBox="1"/>
          <p:nvPr/>
        </p:nvSpPr>
        <p:spPr>
          <a:xfrm>
            <a:off x="1409373" y="806432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9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A510D41-3010-436D-8964-F5DB7CC3AD81}"/>
              </a:ext>
            </a:extLst>
          </p:cNvPr>
          <p:cNvSpPr txBox="1"/>
          <p:nvPr/>
        </p:nvSpPr>
        <p:spPr>
          <a:xfrm>
            <a:off x="964116" y="822794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8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1C0CAC2-E8FC-4528-BAA9-37A1619EAAE6}"/>
              </a:ext>
            </a:extLst>
          </p:cNvPr>
          <p:cNvSpPr txBox="1"/>
          <p:nvPr/>
        </p:nvSpPr>
        <p:spPr>
          <a:xfrm>
            <a:off x="1291392" y="757516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9907B8B-A274-41B8-8D10-FEC41AC1656A}"/>
              </a:ext>
            </a:extLst>
          </p:cNvPr>
          <p:cNvSpPr txBox="1"/>
          <p:nvPr/>
        </p:nvSpPr>
        <p:spPr>
          <a:xfrm>
            <a:off x="3132496" y="4422191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700 MHz in CDCl</a:t>
            </a:r>
            <a:r>
              <a:rPr lang="en-US" sz="800" baseline="-25000" dirty="0"/>
              <a:t>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B10EDA9-1AF7-4982-81B5-2CA322D59670}"/>
              </a:ext>
            </a:extLst>
          </p:cNvPr>
          <p:cNvSpPr txBox="1"/>
          <p:nvPr/>
        </p:nvSpPr>
        <p:spPr>
          <a:xfrm>
            <a:off x="3121479" y="4568620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*overlapped signals </a:t>
            </a:r>
            <a:r>
              <a:rPr lang="en-US" sz="800" i="1" dirty="0"/>
              <a:t>J </a:t>
            </a:r>
            <a:r>
              <a:rPr lang="en-US" sz="800" dirty="0"/>
              <a:t>unresolved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2450988-5824-46EA-9B32-C3EB0669DC5F}"/>
              </a:ext>
            </a:extLst>
          </p:cNvPr>
          <p:cNvSpPr txBox="1"/>
          <p:nvPr/>
        </p:nvSpPr>
        <p:spPr>
          <a:xfrm>
            <a:off x="3135250" y="4696840"/>
            <a:ext cx="342900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The partial assignment was shown in Maldonado, 1996.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9515E7B-7133-4C0C-A133-9CDAB72F7CE5}"/>
              </a:ext>
            </a:extLst>
          </p:cNvPr>
          <p:cNvSpPr txBox="1"/>
          <p:nvPr/>
        </p:nvSpPr>
        <p:spPr>
          <a:xfrm>
            <a:off x="3135250" y="4822220"/>
            <a:ext cx="342900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The chemical shifts were in agreement with the published data.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221B69AA-DF47-46A5-9791-0BCDC90D276D}"/>
              </a:ext>
            </a:extLst>
          </p:cNvPr>
          <p:cNvGraphicFramePr>
            <a:graphicFrameLocks noGrp="1"/>
          </p:cNvGraphicFramePr>
          <p:nvPr/>
        </p:nvGraphicFramePr>
        <p:xfrm>
          <a:off x="3187336" y="5560245"/>
          <a:ext cx="3106078" cy="3840747"/>
        </p:xfrm>
        <a:graphic>
          <a:graphicData uri="http://schemas.openxmlformats.org/drawingml/2006/table">
            <a:tbl>
              <a:tblPr/>
              <a:tblGrid>
                <a:gridCol w="549601">
                  <a:extLst>
                    <a:ext uri="{9D8B030D-6E8A-4147-A177-3AD203B41FA5}">
                      <a16:colId xmlns:a16="http://schemas.microsoft.com/office/drawing/2014/main" val="1182923559"/>
                    </a:ext>
                  </a:extLst>
                </a:gridCol>
                <a:gridCol w="549601">
                  <a:extLst>
                    <a:ext uri="{9D8B030D-6E8A-4147-A177-3AD203B41FA5}">
                      <a16:colId xmlns:a16="http://schemas.microsoft.com/office/drawing/2014/main" val="1329793927"/>
                    </a:ext>
                  </a:extLst>
                </a:gridCol>
                <a:gridCol w="549601">
                  <a:extLst>
                    <a:ext uri="{9D8B030D-6E8A-4147-A177-3AD203B41FA5}">
                      <a16:colId xmlns:a16="http://schemas.microsoft.com/office/drawing/2014/main" val="26503207"/>
                    </a:ext>
                  </a:extLst>
                </a:gridCol>
                <a:gridCol w="907674">
                  <a:extLst>
                    <a:ext uri="{9D8B030D-6E8A-4147-A177-3AD203B41FA5}">
                      <a16:colId xmlns:a16="http://schemas.microsoft.com/office/drawing/2014/main" val="1023714949"/>
                    </a:ext>
                  </a:extLst>
                </a:gridCol>
                <a:gridCol w="549601">
                  <a:extLst>
                    <a:ext uri="{9D8B030D-6E8A-4147-A177-3AD203B41FA5}">
                      <a16:colId xmlns:a16="http://schemas.microsoft.com/office/drawing/2014/main" val="2642867605"/>
                    </a:ext>
                  </a:extLst>
                </a:gridCol>
              </a:tblGrid>
              <a:tr h="16040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5781229"/>
                  </a:ext>
                </a:extLst>
              </a:tr>
              <a:tr h="1653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4/12.4/12.4/4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617344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4/3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2035201"/>
                  </a:ext>
                </a:extLst>
              </a:tr>
              <a:tr h="1653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6182379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396576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5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0731017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1595884"/>
                  </a:ext>
                </a:extLst>
              </a:tr>
              <a:tr h="1558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0943401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/1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291048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500885"/>
                  </a:ext>
                </a:extLst>
              </a:tr>
              <a:tr h="14066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0612011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d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/3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6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476300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2304683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1367103"/>
                  </a:ext>
                </a:extLst>
              </a:tr>
              <a:tr h="16534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9/4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8330611"/>
                  </a:ext>
                </a:extLst>
              </a:tr>
              <a:tr h="1558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9/4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4834476"/>
                  </a:ext>
                </a:extLst>
              </a:tr>
              <a:tr h="14806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9/4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3394857"/>
                  </a:ext>
                </a:extLst>
              </a:tr>
              <a:tr h="14066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9/4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3157148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943505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3442635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5456181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5857775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5689479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0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7343508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4415900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2722295"/>
                  </a:ext>
                </a:extLst>
              </a:tr>
              <a:tr h="13573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1371529"/>
                  </a:ext>
                </a:extLst>
              </a:tr>
            </a:tbl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B79DAD40-7F57-430C-9E6C-B469020E14E3}"/>
              </a:ext>
            </a:extLst>
          </p:cNvPr>
          <p:cNvSpPr txBox="1"/>
          <p:nvPr/>
        </p:nvSpPr>
        <p:spPr>
          <a:xfrm>
            <a:off x="3148825" y="9382397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700 MHz in CDCl</a:t>
            </a:r>
            <a:r>
              <a:rPr lang="en-US" sz="800" baseline="-25000" dirty="0"/>
              <a:t>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2B20E11-E7C5-4BC4-80BB-4F695F064670}"/>
              </a:ext>
            </a:extLst>
          </p:cNvPr>
          <p:cNvSpPr txBox="1"/>
          <p:nvPr/>
        </p:nvSpPr>
        <p:spPr>
          <a:xfrm>
            <a:off x="3137808" y="9513328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*overlapped signals </a:t>
            </a:r>
            <a:r>
              <a:rPr lang="en-US" sz="800" i="1" dirty="0"/>
              <a:t>J </a:t>
            </a:r>
            <a:r>
              <a:rPr lang="en-US" sz="800" dirty="0"/>
              <a:t>unresolved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8FA7796-95DE-4F40-A6AD-B66EBC465297}"/>
              </a:ext>
            </a:extLst>
          </p:cNvPr>
          <p:cNvSpPr txBox="1"/>
          <p:nvPr/>
        </p:nvSpPr>
        <p:spPr>
          <a:xfrm>
            <a:off x="3148825" y="9643674"/>
            <a:ext cx="343716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The chemical shifts were in agreement with the published data (</a:t>
            </a:r>
            <a:r>
              <a:rPr lang="en-US" sz="800" dirty="0" err="1"/>
              <a:t>Ceñal</a:t>
            </a:r>
            <a:r>
              <a:rPr lang="en-US" sz="800" dirty="0"/>
              <a:t>, 1997). </a:t>
            </a:r>
          </a:p>
        </p:txBody>
      </p:sp>
    </p:spTree>
    <p:extLst>
      <p:ext uri="{BB962C8B-B14F-4D97-AF65-F5344CB8AC3E}">
        <p14:creationId xmlns:p14="http://schemas.microsoft.com/office/powerpoint/2010/main" val="40623738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45082"/>
            <a:ext cx="3185039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3-5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dat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en-US" sz="1200" dirty="0"/>
              <a:t> 18-dihydro-conyscabrafuran </a:t>
            </a:r>
          </a:p>
          <a:p>
            <a:endParaRPr lang="en-US" sz="14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DDC3C41-A4EC-4DA6-807C-10B77327D6D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083" y="1391818"/>
            <a:ext cx="1181862" cy="172501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283ED08-21BC-4AD5-B4AE-645CC7A4ED7E}"/>
              </a:ext>
            </a:extLst>
          </p:cNvPr>
          <p:cNvSpPr txBox="1"/>
          <p:nvPr/>
        </p:nvSpPr>
        <p:spPr>
          <a:xfrm>
            <a:off x="449142" y="2912573"/>
            <a:ext cx="219932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 dirty="0"/>
              <a:t> 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3E76BB5-DA48-4629-99B1-BE4532EB10D2}"/>
              </a:ext>
            </a:extLst>
          </p:cNvPr>
          <p:cNvGraphicFramePr>
            <a:graphicFrameLocks noGrp="1"/>
          </p:cNvGraphicFramePr>
          <p:nvPr/>
        </p:nvGraphicFramePr>
        <p:xfrm>
          <a:off x="3344714" y="497561"/>
          <a:ext cx="3094126" cy="3881104"/>
        </p:xfrm>
        <a:graphic>
          <a:graphicData uri="http://schemas.openxmlformats.org/drawingml/2006/table">
            <a:tbl>
              <a:tblPr/>
              <a:tblGrid>
                <a:gridCol w="565685">
                  <a:extLst>
                    <a:ext uri="{9D8B030D-6E8A-4147-A177-3AD203B41FA5}">
                      <a16:colId xmlns:a16="http://schemas.microsoft.com/office/drawing/2014/main" val="188150298"/>
                    </a:ext>
                  </a:extLst>
                </a:gridCol>
                <a:gridCol w="565685">
                  <a:extLst>
                    <a:ext uri="{9D8B030D-6E8A-4147-A177-3AD203B41FA5}">
                      <a16:colId xmlns:a16="http://schemas.microsoft.com/office/drawing/2014/main" val="2447170298"/>
                    </a:ext>
                  </a:extLst>
                </a:gridCol>
                <a:gridCol w="565685">
                  <a:extLst>
                    <a:ext uri="{9D8B030D-6E8A-4147-A177-3AD203B41FA5}">
                      <a16:colId xmlns:a16="http://schemas.microsoft.com/office/drawing/2014/main" val="1593611895"/>
                    </a:ext>
                  </a:extLst>
                </a:gridCol>
                <a:gridCol w="831386">
                  <a:extLst>
                    <a:ext uri="{9D8B030D-6E8A-4147-A177-3AD203B41FA5}">
                      <a16:colId xmlns:a16="http://schemas.microsoft.com/office/drawing/2014/main" val="3065554798"/>
                    </a:ext>
                  </a:extLst>
                </a:gridCol>
                <a:gridCol w="565685">
                  <a:extLst>
                    <a:ext uri="{9D8B030D-6E8A-4147-A177-3AD203B41FA5}">
                      <a16:colId xmlns:a16="http://schemas.microsoft.com/office/drawing/2014/main" val="1533361278"/>
                    </a:ext>
                  </a:extLst>
                </a:gridCol>
              </a:tblGrid>
              <a:tr h="1516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5605140"/>
                  </a:ext>
                </a:extLst>
              </a:tr>
              <a:tr h="1400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4160300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/6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6789018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/7.5/7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3712297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3746000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0205093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2786346"/>
                  </a:ext>
                </a:extLst>
              </a:tr>
              <a:tr h="13300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8744580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0/13.4/3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8949556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7918412"/>
                  </a:ext>
                </a:extLst>
              </a:tr>
              <a:tr h="1400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1541498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2327846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1078695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5190581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/1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3797493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9/13.4/4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6612813"/>
                  </a:ext>
                </a:extLst>
              </a:tr>
              <a:tr h="1240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/13.4/4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6716250"/>
                  </a:ext>
                </a:extLst>
              </a:tr>
              <a:tr h="1400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9/4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1107907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/13.4/4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3450721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5064806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3253990"/>
                  </a:ext>
                </a:extLst>
              </a:tr>
              <a:tr h="153181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1232920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5521764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5557989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4554250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6221847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8132461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0696213"/>
                  </a:ext>
                </a:extLst>
              </a:tr>
              <a:tr h="1283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06036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21F4F09A-9EE0-4E9A-9B31-B524E243C2D8}"/>
              </a:ext>
            </a:extLst>
          </p:cNvPr>
          <p:cNvSpPr txBox="1"/>
          <p:nvPr/>
        </p:nvSpPr>
        <p:spPr>
          <a:xfrm>
            <a:off x="3328385" y="4345530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700 MHz in CDCl</a:t>
            </a:r>
            <a:r>
              <a:rPr lang="en-US" sz="800" baseline="-25000" dirty="0"/>
              <a:t>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BA1018-6083-4B49-A334-EB0560CA8D64}"/>
              </a:ext>
            </a:extLst>
          </p:cNvPr>
          <p:cNvSpPr txBox="1"/>
          <p:nvPr/>
        </p:nvSpPr>
        <p:spPr>
          <a:xfrm>
            <a:off x="3317368" y="4476461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*overlapped signals </a:t>
            </a:r>
            <a:r>
              <a:rPr lang="en-US" sz="800" i="1" dirty="0"/>
              <a:t>J </a:t>
            </a:r>
            <a:r>
              <a:rPr lang="en-US" sz="800" dirty="0"/>
              <a:t>unresolve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FF1C125-F629-47A4-A45C-18D8282F52D6}"/>
              </a:ext>
            </a:extLst>
          </p:cNvPr>
          <p:cNvSpPr txBox="1"/>
          <p:nvPr/>
        </p:nvSpPr>
        <p:spPr>
          <a:xfrm>
            <a:off x="833762" y="229204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33AFC9C-7D91-481C-B4FA-CF1D4A47842F}"/>
              </a:ext>
            </a:extLst>
          </p:cNvPr>
          <p:cNvSpPr txBox="1"/>
          <p:nvPr/>
        </p:nvSpPr>
        <p:spPr>
          <a:xfrm>
            <a:off x="1324050" y="26557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312C2F-DF8D-4C15-BF63-91C09F6155D1}"/>
              </a:ext>
            </a:extLst>
          </p:cNvPr>
          <p:cNvSpPr txBox="1"/>
          <p:nvPr/>
        </p:nvSpPr>
        <p:spPr>
          <a:xfrm>
            <a:off x="707617" y="246465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99F04E5-70FA-4838-BBA2-81BC711271C6}"/>
              </a:ext>
            </a:extLst>
          </p:cNvPr>
          <p:cNvSpPr txBox="1"/>
          <p:nvPr/>
        </p:nvSpPr>
        <p:spPr>
          <a:xfrm>
            <a:off x="1046077" y="225286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DFFB107-E990-4F74-956C-D6934203DF11}"/>
              </a:ext>
            </a:extLst>
          </p:cNvPr>
          <p:cNvSpPr txBox="1"/>
          <p:nvPr/>
        </p:nvSpPr>
        <p:spPr>
          <a:xfrm>
            <a:off x="1595290" y="266240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3E9ECAE-BD5B-4954-9483-B447BF6BC519}"/>
              </a:ext>
            </a:extLst>
          </p:cNvPr>
          <p:cNvSpPr txBox="1"/>
          <p:nvPr/>
        </p:nvSpPr>
        <p:spPr>
          <a:xfrm>
            <a:off x="1672628" y="235009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78A797D-D7B6-4E55-A6E2-82C3FF6BDA54}"/>
              </a:ext>
            </a:extLst>
          </p:cNvPr>
          <p:cNvSpPr txBox="1"/>
          <p:nvPr/>
        </p:nvSpPr>
        <p:spPr>
          <a:xfrm>
            <a:off x="1400069" y="203401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2729EAD-BC29-404B-B450-EB8D2AA4852F}"/>
              </a:ext>
            </a:extLst>
          </p:cNvPr>
          <p:cNvSpPr txBox="1"/>
          <p:nvPr/>
        </p:nvSpPr>
        <p:spPr>
          <a:xfrm>
            <a:off x="1713271" y="17849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369FBAB-9C80-491C-8493-7564CB22CB55}"/>
              </a:ext>
            </a:extLst>
          </p:cNvPr>
          <p:cNvSpPr txBox="1"/>
          <p:nvPr/>
        </p:nvSpPr>
        <p:spPr>
          <a:xfrm>
            <a:off x="1362838" y="155144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76B599-7B8E-4376-AFF5-AAB6E543AE52}"/>
              </a:ext>
            </a:extLst>
          </p:cNvPr>
          <p:cNvSpPr txBox="1"/>
          <p:nvPr/>
        </p:nvSpPr>
        <p:spPr>
          <a:xfrm>
            <a:off x="1482485" y="133022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BA41479-B382-4F9A-B1AD-903EEDBF0FE8}"/>
              </a:ext>
            </a:extLst>
          </p:cNvPr>
          <p:cNvSpPr txBox="1"/>
          <p:nvPr/>
        </p:nvSpPr>
        <p:spPr>
          <a:xfrm>
            <a:off x="1925813" y="161299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6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2F04D44-8A72-4FDC-BCD6-19BC6441674D}"/>
              </a:ext>
            </a:extLst>
          </p:cNvPr>
          <p:cNvSpPr txBox="1"/>
          <p:nvPr/>
        </p:nvSpPr>
        <p:spPr>
          <a:xfrm>
            <a:off x="1969309" y="23394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E7A9D37-E436-4562-B5B9-B1DA6AD34F5A}"/>
              </a:ext>
            </a:extLst>
          </p:cNvPr>
          <p:cNvSpPr txBox="1"/>
          <p:nvPr/>
        </p:nvSpPr>
        <p:spPr>
          <a:xfrm>
            <a:off x="1728296" y="217229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E673103-B378-4915-B5A2-4A8E3BBBE1B6}"/>
              </a:ext>
            </a:extLst>
          </p:cNvPr>
          <p:cNvSpPr txBox="1"/>
          <p:nvPr/>
        </p:nvSpPr>
        <p:spPr>
          <a:xfrm>
            <a:off x="1015834" y="270252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E68F99A-BA3D-4450-A962-4D3C06C04BCE}"/>
              </a:ext>
            </a:extLst>
          </p:cNvPr>
          <p:cNvSpPr txBox="1"/>
          <p:nvPr/>
        </p:nvSpPr>
        <p:spPr>
          <a:xfrm>
            <a:off x="836885" y="302870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254D681-F52F-41F8-A37A-F08DE8FE55F1}"/>
              </a:ext>
            </a:extLst>
          </p:cNvPr>
          <p:cNvSpPr txBox="1"/>
          <p:nvPr/>
        </p:nvSpPr>
        <p:spPr>
          <a:xfrm>
            <a:off x="1324050" y="248966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BF2769F-FBD0-44CD-94EE-798F8E594BEE}"/>
              </a:ext>
            </a:extLst>
          </p:cNvPr>
          <p:cNvSpPr txBox="1"/>
          <p:nvPr/>
        </p:nvSpPr>
        <p:spPr>
          <a:xfrm>
            <a:off x="779872" y="274170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4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32C4DAD-14AB-FA56-984D-BB060E5CE13A}"/>
              </a:ext>
            </a:extLst>
          </p:cNvPr>
          <p:cNvSpPr/>
          <p:nvPr/>
        </p:nvSpPr>
        <p:spPr>
          <a:xfrm>
            <a:off x="169338" y="4992070"/>
            <a:ext cx="2387000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3-6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dat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 err="1"/>
              <a:t>hautriwaic</a:t>
            </a:r>
            <a:r>
              <a:rPr lang="en-US" sz="1200" dirty="0"/>
              <a:t> acid </a:t>
            </a:r>
          </a:p>
          <a:p>
            <a:endParaRPr lang="en-US" sz="1400" dirty="0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7CA9840-2288-395D-592A-BB0A7AAF01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7973414"/>
              </p:ext>
            </p:extLst>
          </p:nvPr>
        </p:nvGraphicFramePr>
        <p:xfrm>
          <a:off x="3344714" y="5216112"/>
          <a:ext cx="3094127" cy="4049808"/>
        </p:xfrm>
        <a:graphic>
          <a:graphicData uri="http://schemas.openxmlformats.org/drawingml/2006/table">
            <a:tbl>
              <a:tblPr/>
              <a:tblGrid>
                <a:gridCol w="539457">
                  <a:extLst>
                    <a:ext uri="{9D8B030D-6E8A-4147-A177-3AD203B41FA5}">
                      <a16:colId xmlns:a16="http://schemas.microsoft.com/office/drawing/2014/main" val="1637963934"/>
                    </a:ext>
                  </a:extLst>
                </a:gridCol>
                <a:gridCol w="539457">
                  <a:extLst>
                    <a:ext uri="{9D8B030D-6E8A-4147-A177-3AD203B41FA5}">
                      <a16:colId xmlns:a16="http://schemas.microsoft.com/office/drawing/2014/main" val="1630254375"/>
                    </a:ext>
                  </a:extLst>
                </a:gridCol>
                <a:gridCol w="539457">
                  <a:extLst>
                    <a:ext uri="{9D8B030D-6E8A-4147-A177-3AD203B41FA5}">
                      <a16:colId xmlns:a16="http://schemas.microsoft.com/office/drawing/2014/main" val="457132321"/>
                    </a:ext>
                  </a:extLst>
                </a:gridCol>
                <a:gridCol w="936299">
                  <a:extLst>
                    <a:ext uri="{9D8B030D-6E8A-4147-A177-3AD203B41FA5}">
                      <a16:colId xmlns:a16="http://schemas.microsoft.com/office/drawing/2014/main" val="2844582167"/>
                    </a:ext>
                  </a:extLst>
                </a:gridCol>
                <a:gridCol w="539457">
                  <a:extLst>
                    <a:ext uri="{9D8B030D-6E8A-4147-A177-3AD203B41FA5}">
                      <a16:colId xmlns:a16="http://schemas.microsoft.com/office/drawing/2014/main" val="1260388338"/>
                    </a:ext>
                  </a:extLst>
                </a:gridCol>
              </a:tblGrid>
              <a:tr h="1607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.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itchFamily="2" charset="2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.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itchFamily="2" charset="2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6616664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6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1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713807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1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440508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036147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8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852739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7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/3.6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.1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9437887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.8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0139705"/>
                  </a:ext>
                </a:extLst>
              </a:tr>
              <a:tr h="136601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2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8822459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/3.1/2.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879426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6060549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a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153297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b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1162103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3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2900193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37093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319579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a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/13.3/5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7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4856838"/>
                  </a:ext>
                </a:extLst>
              </a:tr>
              <a:tr h="136601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b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/13.3/3.7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7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46422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a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2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/13.3/3.7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972081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b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3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d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/13.5/5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1516862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.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383685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1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6667044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/1.4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497227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6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1314471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0053179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2.6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592725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a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445128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b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9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275162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8</a:t>
                      </a:r>
                    </a:p>
                  </a:txBody>
                  <a:tcPr marL="9353" marR="9353" marT="9353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775056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B076FEF-358B-BC92-E143-8A04F4247401}"/>
              </a:ext>
            </a:extLst>
          </p:cNvPr>
          <p:cNvSpPr txBox="1"/>
          <p:nvPr/>
        </p:nvSpPr>
        <p:spPr>
          <a:xfrm>
            <a:off x="3328385" y="9283290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700 MHz in CDCl</a:t>
            </a:r>
            <a:r>
              <a:rPr lang="en-US" sz="800" baseline="-25000" dirty="0"/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C4FBC8-1FA8-9811-773E-9506D7EC98C9}"/>
              </a:ext>
            </a:extLst>
          </p:cNvPr>
          <p:cNvSpPr txBox="1"/>
          <p:nvPr/>
        </p:nvSpPr>
        <p:spPr>
          <a:xfrm>
            <a:off x="3317368" y="9419301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*overlapped signals </a:t>
            </a:r>
            <a:r>
              <a:rPr lang="en-US" sz="800" i="1" dirty="0"/>
              <a:t>J </a:t>
            </a:r>
            <a:r>
              <a:rPr lang="en-US" sz="800" dirty="0"/>
              <a:t>unresolv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C61CE51-3611-703E-C0C8-A512132D5868}"/>
              </a:ext>
            </a:extLst>
          </p:cNvPr>
          <p:cNvSpPr txBox="1"/>
          <p:nvPr/>
        </p:nvSpPr>
        <p:spPr>
          <a:xfrm>
            <a:off x="3331139" y="9555312"/>
            <a:ext cx="342900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The chemical shifts were in agreement with the published data</a:t>
            </a:r>
            <a:r>
              <a:rPr lang="en-US" sz="800" dirty="0">
                <a:effectLst/>
                <a:latin typeface="Calibri" panose="020F0502020204030204" pitchFamily="34" charset="0"/>
                <a:ea typeface="Yu Gothic" panose="020B0400000000000000" pitchFamily="34" charset="-128"/>
              </a:rPr>
              <a:t> (Huang, 2010)</a:t>
            </a:r>
            <a:r>
              <a:rPr lang="en-US" sz="800" dirty="0"/>
              <a:t>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6CDDD4C-4E0F-011F-1B6E-ED63E7C4D58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302" y="6310040"/>
            <a:ext cx="1155040" cy="2003298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70D69577-40E9-7149-6939-A9A41C74EDCC}"/>
              </a:ext>
            </a:extLst>
          </p:cNvPr>
          <p:cNvSpPr txBox="1"/>
          <p:nvPr/>
        </p:nvSpPr>
        <p:spPr>
          <a:xfrm>
            <a:off x="572503" y="732674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AF5DD8F-525C-FE7F-EB14-9A59E647581E}"/>
              </a:ext>
            </a:extLst>
          </p:cNvPr>
          <p:cNvSpPr txBox="1"/>
          <p:nvPr/>
        </p:nvSpPr>
        <p:spPr>
          <a:xfrm>
            <a:off x="1111778" y="757521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D96F0B5-26AE-F2A2-13DA-3B3831172E87}"/>
              </a:ext>
            </a:extLst>
          </p:cNvPr>
          <p:cNvSpPr txBox="1"/>
          <p:nvPr/>
        </p:nvSpPr>
        <p:spPr>
          <a:xfrm>
            <a:off x="561486" y="758623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9BDE7AE-560E-3FD8-A140-79279FB944D8}"/>
              </a:ext>
            </a:extLst>
          </p:cNvPr>
          <p:cNvSpPr txBox="1"/>
          <p:nvPr/>
        </p:nvSpPr>
        <p:spPr>
          <a:xfrm>
            <a:off x="833805" y="71945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345136F-628D-1201-EE6B-400E9D301A2B}"/>
              </a:ext>
            </a:extLst>
          </p:cNvPr>
          <p:cNvSpPr txBox="1"/>
          <p:nvPr/>
        </p:nvSpPr>
        <p:spPr>
          <a:xfrm>
            <a:off x="1383018" y="758191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7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088FFF5-326A-EE46-DCDE-EC7258047512}"/>
              </a:ext>
            </a:extLst>
          </p:cNvPr>
          <p:cNvSpPr txBox="1"/>
          <p:nvPr/>
        </p:nvSpPr>
        <p:spPr>
          <a:xfrm>
            <a:off x="1460356" y="73022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AFCA24F-5444-D217-C665-38EB37E487EB}"/>
              </a:ext>
            </a:extLst>
          </p:cNvPr>
          <p:cNvSpPr txBox="1"/>
          <p:nvPr/>
        </p:nvSpPr>
        <p:spPr>
          <a:xfrm>
            <a:off x="1187797" y="695352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C17024A-2A23-5498-0054-7977679ABCA3}"/>
              </a:ext>
            </a:extLst>
          </p:cNvPr>
          <p:cNvSpPr txBox="1"/>
          <p:nvPr/>
        </p:nvSpPr>
        <p:spPr>
          <a:xfrm>
            <a:off x="1500999" y="67044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9341D81-F6B2-C060-A0F3-2BC93F1A3211}"/>
              </a:ext>
            </a:extLst>
          </p:cNvPr>
          <p:cNvSpPr txBox="1"/>
          <p:nvPr/>
        </p:nvSpPr>
        <p:spPr>
          <a:xfrm>
            <a:off x="1150566" y="647095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4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194D5A6-C89E-46EF-A5B4-8C25A139F0B1}"/>
              </a:ext>
            </a:extLst>
          </p:cNvPr>
          <p:cNvSpPr txBox="1"/>
          <p:nvPr/>
        </p:nvSpPr>
        <p:spPr>
          <a:xfrm>
            <a:off x="1270213" y="624973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DC61FE5-7DFE-604B-60E3-8AFF847898A1}"/>
              </a:ext>
            </a:extLst>
          </p:cNvPr>
          <p:cNvSpPr txBox="1"/>
          <p:nvPr/>
        </p:nvSpPr>
        <p:spPr>
          <a:xfrm>
            <a:off x="1713541" y="653250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F301C9D-3873-FCDF-BFE4-E234FE40FF30}"/>
              </a:ext>
            </a:extLst>
          </p:cNvPr>
          <p:cNvSpPr txBox="1"/>
          <p:nvPr/>
        </p:nvSpPr>
        <p:spPr>
          <a:xfrm>
            <a:off x="1757037" y="72589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CA91630-5BA8-7570-B1FE-BFAB1DFA02DD}"/>
              </a:ext>
            </a:extLst>
          </p:cNvPr>
          <p:cNvSpPr txBox="1"/>
          <p:nvPr/>
        </p:nvSpPr>
        <p:spPr>
          <a:xfrm>
            <a:off x="1516024" y="709180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08B38F8-80CA-D602-D2AE-34AFF85F4B29}"/>
              </a:ext>
            </a:extLst>
          </p:cNvPr>
          <p:cNvSpPr txBox="1"/>
          <p:nvPr/>
        </p:nvSpPr>
        <p:spPr>
          <a:xfrm>
            <a:off x="953395" y="788488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763B262-8B87-B313-46D0-B305765A961D}"/>
              </a:ext>
            </a:extLst>
          </p:cNvPr>
          <p:cNvSpPr txBox="1"/>
          <p:nvPr/>
        </p:nvSpPr>
        <p:spPr>
          <a:xfrm>
            <a:off x="702134" y="792273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CC828CB-965C-C3F5-8D40-82880A822C87}"/>
              </a:ext>
            </a:extLst>
          </p:cNvPr>
          <p:cNvSpPr txBox="1"/>
          <p:nvPr/>
        </p:nvSpPr>
        <p:spPr>
          <a:xfrm>
            <a:off x="1111778" y="740917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18084269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>
            <a:extLst>
              <a:ext uri="{FF2B5EF4-FFF2-40B4-BE49-F238E27FC236}">
                <a16:creationId xmlns:a16="http://schemas.microsoft.com/office/drawing/2014/main" id="{E59B60CD-07F1-AA1F-F4FC-D7CA12C870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2312" y="1469851"/>
            <a:ext cx="1155040" cy="2001622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45082"/>
            <a:ext cx="24026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3-7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dat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en-US" sz="1400" dirty="0"/>
              <a:t> </a:t>
            </a:r>
            <a:r>
              <a:rPr lang="en-US" sz="1200" dirty="0" err="1"/>
              <a:t>hardwickiic</a:t>
            </a:r>
            <a:r>
              <a:rPr lang="en-US" sz="1200" dirty="0"/>
              <a:t> aci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F4F09A-9EE0-4E9A-9B31-B524E243C2D8}"/>
              </a:ext>
            </a:extLst>
          </p:cNvPr>
          <p:cNvSpPr txBox="1"/>
          <p:nvPr/>
        </p:nvSpPr>
        <p:spPr>
          <a:xfrm>
            <a:off x="3328385" y="4345530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700 MHz in CDCl</a:t>
            </a:r>
            <a:r>
              <a:rPr lang="en-US" sz="800" baseline="-25000" dirty="0"/>
              <a:t>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BA1018-6083-4B49-A334-EB0560CA8D64}"/>
              </a:ext>
            </a:extLst>
          </p:cNvPr>
          <p:cNvSpPr txBox="1"/>
          <p:nvPr/>
        </p:nvSpPr>
        <p:spPr>
          <a:xfrm>
            <a:off x="3317368" y="4476461"/>
            <a:ext cx="343175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*overlapped signals </a:t>
            </a:r>
            <a:r>
              <a:rPr lang="en-US" sz="800" i="1" dirty="0"/>
              <a:t>J </a:t>
            </a:r>
            <a:r>
              <a:rPr lang="en-US" sz="800" dirty="0"/>
              <a:t>unresolved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87117A1-6887-549E-124F-7E3DDB16CF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1648991"/>
              </p:ext>
            </p:extLst>
          </p:nvPr>
        </p:nvGraphicFramePr>
        <p:xfrm>
          <a:off x="3415145" y="326675"/>
          <a:ext cx="3094125" cy="4017059"/>
        </p:xfrm>
        <a:graphic>
          <a:graphicData uri="http://schemas.openxmlformats.org/drawingml/2006/table">
            <a:tbl>
              <a:tblPr/>
              <a:tblGrid>
                <a:gridCol w="552749">
                  <a:extLst>
                    <a:ext uri="{9D8B030D-6E8A-4147-A177-3AD203B41FA5}">
                      <a16:colId xmlns:a16="http://schemas.microsoft.com/office/drawing/2014/main" val="2932238621"/>
                    </a:ext>
                  </a:extLst>
                </a:gridCol>
                <a:gridCol w="552749">
                  <a:extLst>
                    <a:ext uri="{9D8B030D-6E8A-4147-A177-3AD203B41FA5}">
                      <a16:colId xmlns:a16="http://schemas.microsoft.com/office/drawing/2014/main" val="1323235209"/>
                    </a:ext>
                  </a:extLst>
                </a:gridCol>
                <a:gridCol w="552749">
                  <a:extLst>
                    <a:ext uri="{9D8B030D-6E8A-4147-A177-3AD203B41FA5}">
                      <a16:colId xmlns:a16="http://schemas.microsoft.com/office/drawing/2014/main" val="3742739163"/>
                    </a:ext>
                  </a:extLst>
                </a:gridCol>
                <a:gridCol w="883129">
                  <a:extLst>
                    <a:ext uri="{9D8B030D-6E8A-4147-A177-3AD203B41FA5}">
                      <a16:colId xmlns:a16="http://schemas.microsoft.com/office/drawing/2014/main" val="2570142224"/>
                    </a:ext>
                  </a:extLst>
                </a:gridCol>
                <a:gridCol w="552749">
                  <a:extLst>
                    <a:ext uri="{9D8B030D-6E8A-4147-A177-3AD203B41FA5}">
                      <a16:colId xmlns:a16="http://schemas.microsoft.com/office/drawing/2014/main" val="3626048486"/>
                    </a:ext>
                  </a:extLst>
                </a:gridCol>
              </a:tblGrid>
              <a:tr h="165311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itchFamily="2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H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d</a:t>
                      </a:r>
                      <a:r>
                        <a:rPr lang="en-US" sz="8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Symbol" pitchFamily="2" charset="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1576671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9869342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9799260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5339431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8374828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/2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1740365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6420308"/>
                  </a:ext>
                </a:extLst>
              </a:tr>
              <a:tr h="140514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5332791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/3.3/3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2819734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/13.1/3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3576329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8099543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266301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3094588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9216999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</a:rPr>
                        <a:t>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750300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6176721"/>
                  </a:ext>
                </a:extLst>
              </a:tr>
              <a:tr h="14051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9937430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6391832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m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9970183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8280266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277761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4197024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8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4749562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2691171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2.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4931912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1706727"/>
                  </a:ext>
                </a:extLst>
              </a:tr>
              <a:tr h="148780"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115887"/>
                  </a:ext>
                </a:extLst>
              </a:tr>
            </a:tbl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874A7ED4-5ACE-7F74-D8D4-53B85790CB62}"/>
              </a:ext>
            </a:extLst>
          </p:cNvPr>
          <p:cNvSpPr txBox="1"/>
          <p:nvPr/>
        </p:nvSpPr>
        <p:spPr>
          <a:xfrm>
            <a:off x="3336200" y="4615704"/>
            <a:ext cx="37777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The chemical shifts were in agreement with the published data (</a:t>
            </a:r>
            <a:r>
              <a:rPr lang="en-US" sz="800" dirty="0">
                <a:effectLst/>
                <a:ea typeface="Yu Gothic" panose="020B0400000000000000" pitchFamily="34" charset="-128"/>
              </a:rPr>
              <a:t>Vargas, 2015)</a:t>
            </a:r>
            <a:r>
              <a:rPr lang="en-US" sz="800" dirty="0"/>
              <a:t>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A9BA273-6720-0536-7865-E12ABB09F812}"/>
              </a:ext>
            </a:extLst>
          </p:cNvPr>
          <p:cNvSpPr txBox="1"/>
          <p:nvPr/>
        </p:nvSpPr>
        <p:spPr>
          <a:xfrm>
            <a:off x="936487" y="24706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A08EE44-79D1-0D88-6A17-1685532F6896}"/>
              </a:ext>
            </a:extLst>
          </p:cNvPr>
          <p:cNvSpPr txBox="1"/>
          <p:nvPr/>
        </p:nvSpPr>
        <p:spPr>
          <a:xfrm>
            <a:off x="1475762" y="271913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67CF9E9-F577-6BD8-10F7-2964BB41B095}"/>
              </a:ext>
            </a:extLst>
          </p:cNvPr>
          <p:cNvSpPr txBox="1"/>
          <p:nvPr/>
        </p:nvSpPr>
        <p:spPr>
          <a:xfrm>
            <a:off x="925470" y="273015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2CC65C6-CCAF-0515-E11F-09B10D6DA6C8}"/>
              </a:ext>
            </a:extLst>
          </p:cNvPr>
          <p:cNvSpPr txBox="1"/>
          <p:nvPr/>
        </p:nvSpPr>
        <p:spPr>
          <a:xfrm>
            <a:off x="1197789" y="233845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6D35990-20A2-DF3B-D558-21CD2442098F}"/>
              </a:ext>
            </a:extLst>
          </p:cNvPr>
          <p:cNvSpPr txBox="1"/>
          <p:nvPr/>
        </p:nvSpPr>
        <p:spPr>
          <a:xfrm>
            <a:off x="1747002" y="272583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7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1262063-48C8-3D37-1172-FCD6377B3017}"/>
              </a:ext>
            </a:extLst>
          </p:cNvPr>
          <p:cNvSpPr txBox="1"/>
          <p:nvPr/>
        </p:nvSpPr>
        <p:spPr>
          <a:xfrm>
            <a:off x="1824340" y="244618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D9C8204-0BF4-51F0-31BB-EBBB5623C8F1}"/>
              </a:ext>
            </a:extLst>
          </p:cNvPr>
          <p:cNvSpPr txBox="1"/>
          <p:nvPr/>
        </p:nvSpPr>
        <p:spPr>
          <a:xfrm>
            <a:off x="1551781" y="209743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870D324-1270-7226-659C-BBE82FC9E4E2}"/>
              </a:ext>
            </a:extLst>
          </p:cNvPr>
          <p:cNvSpPr txBox="1"/>
          <p:nvPr/>
        </p:nvSpPr>
        <p:spPr>
          <a:xfrm>
            <a:off x="1864983" y="184835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48356EF-1FC1-C9D3-1137-3EB9FAA725F3}"/>
              </a:ext>
            </a:extLst>
          </p:cNvPr>
          <p:cNvSpPr txBox="1"/>
          <p:nvPr/>
        </p:nvSpPr>
        <p:spPr>
          <a:xfrm>
            <a:off x="1514550" y="161486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4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2FAF034-1402-FF40-9452-F793651321F6}"/>
              </a:ext>
            </a:extLst>
          </p:cNvPr>
          <p:cNvSpPr txBox="1"/>
          <p:nvPr/>
        </p:nvSpPr>
        <p:spPr>
          <a:xfrm>
            <a:off x="1634197" y="139364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A6A175C-9704-567D-59CF-5FA433AD7811}"/>
              </a:ext>
            </a:extLst>
          </p:cNvPr>
          <p:cNvSpPr txBox="1"/>
          <p:nvPr/>
        </p:nvSpPr>
        <p:spPr>
          <a:xfrm>
            <a:off x="2077525" y="167642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63A2A4C-D2FD-246C-5E20-124ACC646E2F}"/>
              </a:ext>
            </a:extLst>
          </p:cNvPr>
          <p:cNvSpPr txBox="1"/>
          <p:nvPr/>
        </p:nvSpPr>
        <p:spPr>
          <a:xfrm>
            <a:off x="2121021" y="240285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4616EFD-86A4-44AF-F2E1-F9FD227A8C85}"/>
              </a:ext>
            </a:extLst>
          </p:cNvPr>
          <p:cNvSpPr txBox="1"/>
          <p:nvPr/>
        </p:nvSpPr>
        <p:spPr>
          <a:xfrm>
            <a:off x="1880008" y="223572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66B0FCA-CF21-74E3-6E9F-EB3D2D002849}"/>
              </a:ext>
            </a:extLst>
          </p:cNvPr>
          <p:cNvSpPr txBox="1"/>
          <p:nvPr/>
        </p:nvSpPr>
        <p:spPr>
          <a:xfrm>
            <a:off x="1388304" y="309530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436F0B0-96BD-30D0-C420-20279BF7596D}"/>
              </a:ext>
            </a:extLst>
          </p:cNvPr>
          <p:cNvSpPr txBox="1"/>
          <p:nvPr/>
        </p:nvSpPr>
        <p:spPr>
          <a:xfrm>
            <a:off x="1066118" y="306665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D3F5146-EA0E-B403-69EC-51CDA849400C}"/>
              </a:ext>
            </a:extLst>
          </p:cNvPr>
          <p:cNvSpPr txBox="1"/>
          <p:nvPr/>
        </p:nvSpPr>
        <p:spPr>
          <a:xfrm>
            <a:off x="1475762" y="255308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6682921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198D522-4B08-4E99-8A3C-8A0099B11F0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1788" y="873995"/>
            <a:ext cx="596438" cy="9767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321090"/>
            <a:ext cx="2792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1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</a:t>
            </a:r>
            <a:r>
              <a:rPr lang="en-US" sz="1200" dirty="0" err="1"/>
              <a:t>bacchasmacranone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526169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/>
              <a:t>1</a:t>
            </a:r>
            <a:r>
              <a:rPr lang="en-US" sz="1200" dirty="0"/>
              <a:t>H NMR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268702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DEPTQ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E5E0255E-9DEE-4198-B2F9-7ACBC9AC03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9245" y="5816342"/>
            <a:ext cx="5663565" cy="391191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3E2D116-44D4-42CE-AEF9-89B2C43DB5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3512" y="833605"/>
            <a:ext cx="5955030" cy="380333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1A7775B9-719B-820B-6FE0-309CD290262B}"/>
              </a:ext>
            </a:extLst>
          </p:cNvPr>
          <p:cNvSpPr/>
          <p:nvPr/>
        </p:nvSpPr>
        <p:spPr>
          <a:xfrm>
            <a:off x="140665" y="115592"/>
            <a:ext cx="24925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200" b="1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S4  NMR spectra of the diterpenoids</a:t>
            </a:r>
          </a:p>
        </p:txBody>
      </p:sp>
    </p:spTree>
    <p:extLst>
      <p:ext uri="{BB962C8B-B14F-4D97-AF65-F5344CB8AC3E}">
        <p14:creationId xmlns:p14="http://schemas.microsoft.com/office/powerpoint/2010/main" val="21691913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248785"/>
            <a:ext cx="3151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2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8-</a:t>
            </a:r>
            <a:r>
              <a:rPr lang="de-DE" sz="1200" i="1" dirty="0">
                <a:ea typeface="MS Mincho"/>
              </a:rPr>
              <a:t>epi</a:t>
            </a:r>
            <a:r>
              <a:rPr lang="de-DE" sz="1200" dirty="0">
                <a:ea typeface="MS Mincho"/>
              </a:rPr>
              <a:t>-</a:t>
            </a:r>
            <a:r>
              <a:rPr lang="en-US" sz="1200" dirty="0" err="1"/>
              <a:t>bacchasmacranone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504226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/>
              <a:t>1</a:t>
            </a:r>
            <a:r>
              <a:rPr lang="en-US" sz="1200" dirty="0"/>
              <a:t>H NMR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403689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DEPTQ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840099B-E956-4A12-A8B1-462AAD729F1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0637" y="873995"/>
            <a:ext cx="596438" cy="9767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E6029F5-A535-4922-9D72-1584C5BBDC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916" y="812606"/>
            <a:ext cx="5912168" cy="380333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B5EE434-2F2F-4EA2-A274-322E4C53A1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2916" y="5816342"/>
            <a:ext cx="5875020" cy="3911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01461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590" y="997087"/>
            <a:ext cx="6372225" cy="38919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B1E5758-8A6D-41BE-9333-7868BC200BD1}"/>
              </a:ext>
            </a:extLst>
          </p:cNvPr>
          <p:cNvSpPr/>
          <p:nvPr/>
        </p:nvSpPr>
        <p:spPr>
          <a:xfrm>
            <a:off x="140665" y="177740"/>
            <a:ext cx="3151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ea typeface="MS Mincho"/>
              </a:rPr>
              <a:t>S4-2  </a:t>
            </a:r>
            <a:r>
              <a:rPr lang="de-DE" sz="1200" dirty="0">
                <a:ea typeface="MS Mincho"/>
              </a:rPr>
              <a:t>NMR </a:t>
            </a:r>
            <a:r>
              <a:rPr lang="de-DE" sz="1200" dirty="0" err="1">
                <a:ea typeface="MS Mincho"/>
              </a:rPr>
              <a:t>spectra</a:t>
            </a:r>
            <a:r>
              <a:rPr lang="de-DE" sz="1200" dirty="0">
                <a:ea typeface="MS Mincho"/>
              </a:rPr>
              <a:t> </a:t>
            </a:r>
            <a:r>
              <a:rPr lang="de-DE" sz="1200" dirty="0" err="1">
                <a:ea typeface="MS Mincho"/>
              </a:rPr>
              <a:t>for</a:t>
            </a:r>
            <a:r>
              <a:rPr lang="de-DE" sz="1200" dirty="0">
                <a:ea typeface="MS Mincho"/>
              </a:rPr>
              <a:t> 8-</a:t>
            </a:r>
            <a:r>
              <a:rPr lang="de-DE" sz="1200" i="1" dirty="0">
                <a:ea typeface="MS Mincho"/>
              </a:rPr>
              <a:t>epi</a:t>
            </a:r>
            <a:r>
              <a:rPr lang="de-DE" sz="1200" dirty="0">
                <a:ea typeface="MS Mincho"/>
              </a:rPr>
              <a:t>-</a:t>
            </a:r>
            <a:r>
              <a:rPr lang="en-US" sz="1200" dirty="0" err="1"/>
              <a:t>bacchasmacranone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88A6-CC46-4D28-8D66-99D55053A741}"/>
              </a:ext>
            </a:extLst>
          </p:cNvPr>
          <p:cNvSpPr txBox="1"/>
          <p:nvPr/>
        </p:nvSpPr>
        <p:spPr>
          <a:xfrm>
            <a:off x="140665" y="479909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Phase sensitive HSQC, </a:t>
            </a:r>
            <a:r>
              <a:rPr lang="en-US" sz="1200" baseline="30000" dirty="0"/>
              <a:t> </a:t>
            </a:r>
            <a:r>
              <a:rPr lang="en-US" sz="1200" dirty="0"/>
              <a:t>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B49ADC-16BE-4A52-ADDF-DBC5BC428E8D}"/>
              </a:ext>
            </a:extLst>
          </p:cNvPr>
          <p:cNvSpPr txBox="1"/>
          <p:nvPr/>
        </p:nvSpPr>
        <p:spPr>
          <a:xfrm>
            <a:off x="140665" y="5551920"/>
            <a:ext cx="34330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HMBC full range in CDCl</a:t>
            </a:r>
            <a:r>
              <a:rPr lang="en-US" sz="1200" baseline="-25000" dirty="0"/>
              <a:t>3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840099B-E956-4A12-A8B1-462AAD729F1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3511" y="177740"/>
            <a:ext cx="596438" cy="97674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905" y="5690420"/>
            <a:ext cx="5883593" cy="38919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461484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35</Words>
  <Application>Microsoft Office PowerPoint</Application>
  <PresentationFormat>A4-Papier (210 x 297 mm)</PresentationFormat>
  <Paragraphs>1186</Paragraphs>
  <Slides>1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8</vt:i4>
      </vt:variant>
    </vt:vector>
  </HeadingPairs>
  <TitlesOfParts>
    <vt:vector size="24" baseType="lpstr">
      <vt:lpstr>Aptos</vt:lpstr>
      <vt:lpstr>Arial</vt:lpstr>
      <vt:lpstr>Calibri</vt:lpstr>
      <vt:lpstr>Calibri Light</vt:lpstr>
      <vt:lpstr>Symbol</vt:lpstr>
      <vt:lpstr>Tema de 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Olga</dc:creator>
  <cp:lastModifiedBy>Tobias Koellner</cp:lastModifiedBy>
  <cp:revision>150</cp:revision>
  <cp:lastPrinted>2024-06-07T13:12:51Z</cp:lastPrinted>
  <dcterms:created xsi:type="dcterms:W3CDTF">2024-02-06T08:29:50Z</dcterms:created>
  <dcterms:modified xsi:type="dcterms:W3CDTF">2024-08-27T08:04:53Z</dcterms:modified>
</cp:coreProperties>
</file>